
<file path=[Content_Types].xml><?xml version="1.0" encoding="utf-8"?>
<Types xmlns="http://schemas.openxmlformats.org/package/2006/content-types"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92" r:id="rId2"/>
    <p:sldId id="293" r:id="rId3"/>
    <p:sldId id="267" r:id="rId4"/>
    <p:sldId id="277" r:id="rId5"/>
    <p:sldId id="284" r:id="rId6"/>
    <p:sldId id="294" r:id="rId7"/>
    <p:sldId id="295" r:id="rId8"/>
    <p:sldId id="296" r:id="rId9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4" orient="horz" pos="3198" userDrawn="1">
          <p15:clr>
            <a:srgbClr val="A4A3A4"/>
          </p15:clr>
        </p15:guide>
        <p15:guide id="5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16" autoAdjust="0"/>
    <p:restoredTop sz="94660"/>
  </p:normalViewPr>
  <p:slideViewPr>
    <p:cSldViewPr snapToGrid="0" showGuides="1">
      <p:cViewPr varScale="1">
        <p:scale>
          <a:sx n="56" d="100"/>
          <a:sy n="56" d="100"/>
        </p:scale>
        <p:origin x="2688" y="90"/>
      </p:cViewPr>
      <p:guideLst>
        <p:guide orient="horz" pos="319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OsCHI%20qRT%202021\qRT%20UV%20CHI%20&#51204;&#52404;%20&#53685;&#54633;&#48376;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Developmental%20stage%20CHI%20%20&#51204;&#52404;%20&#53685;&#54633;&#48376;%20UBQ1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AMSUNG\Desktop\qRT%20UV%20CHI%20&#51204;&#52404;%20&#53685;&#54633;&#48376;%20UBQ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7'!$AC$29:$AC$34</c:f>
                <c:numCache>
                  <c:formatCode>General</c:formatCode>
                  <c:ptCount val="6"/>
                  <c:pt idx="0">
                    <c:v>3.1874919251836241E-2</c:v>
                  </c:pt>
                  <c:pt idx="1">
                    <c:v>9.1957478667136217E-3</c:v>
                  </c:pt>
                  <c:pt idx="2">
                    <c:v>2.9177536921395578E-2</c:v>
                  </c:pt>
                  <c:pt idx="3">
                    <c:v>1.6966495713919925E-2</c:v>
                  </c:pt>
                  <c:pt idx="4">
                    <c:v>6.5911739043224477E-2</c:v>
                  </c:pt>
                  <c:pt idx="5">
                    <c:v>4.314064267652943E-2</c:v>
                  </c:pt>
                </c:numCache>
              </c:numRef>
            </c:plus>
            <c:minus>
              <c:numRef>
                <c:f>'CHI7'!$AC$29:$AC$34</c:f>
                <c:numCache>
                  <c:formatCode>General</c:formatCode>
                  <c:ptCount val="6"/>
                  <c:pt idx="0">
                    <c:v>3.1874919251836241E-2</c:v>
                  </c:pt>
                  <c:pt idx="1">
                    <c:v>9.1957478667136217E-3</c:v>
                  </c:pt>
                  <c:pt idx="2">
                    <c:v>2.9177536921395578E-2</c:v>
                  </c:pt>
                  <c:pt idx="3">
                    <c:v>1.6966495713919925E-2</c:v>
                  </c:pt>
                  <c:pt idx="4">
                    <c:v>6.5911739043224477E-2</c:v>
                  </c:pt>
                  <c:pt idx="5">
                    <c:v>4.314064267652943E-2</c:v>
                  </c:pt>
                </c:numCache>
              </c:numRef>
            </c:minus>
          </c:errBars>
          <c:cat>
            <c:numRef>
              <c:f>'CHI7'!$AA$29:$AA$34</c:f>
              <c:numCache>
                <c:formatCode>General</c:formatCode>
                <c:ptCount val="6"/>
              </c:numCache>
            </c:numRef>
          </c:cat>
          <c:val>
            <c:numRef>
              <c:f>'CHI7'!$AB$29:$AB$34</c:f>
              <c:numCache>
                <c:formatCode>0.00</c:formatCode>
                <c:ptCount val="6"/>
                <c:pt idx="0">
                  <c:v>0.11653186993301216</c:v>
                </c:pt>
                <c:pt idx="1">
                  <c:v>4.0495636081919473E-2</c:v>
                </c:pt>
                <c:pt idx="2">
                  <c:v>0.27820585833298006</c:v>
                </c:pt>
                <c:pt idx="3">
                  <c:v>0.26148416553743092</c:v>
                </c:pt>
                <c:pt idx="4">
                  <c:v>0.15668911873334215</c:v>
                </c:pt>
                <c:pt idx="5">
                  <c:v>0.8920275385006346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7AA5-4220-99B6-357A20991F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2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4'!$AC$28:$AC$32</c:f>
                <c:numCache>
                  <c:formatCode>General</c:formatCode>
                  <c:ptCount val="5"/>
                  <c:pt idx="0">
                    <c:v>0.12202225833420895</c:v>
                  </c:pt>
                  <c:pt idx="1">
                    <c:v>0.14313654394113848</c:v>
                  </c:pt>
                  <c:pt idx="2">
                    <c:v>6.8002353772639676E-2</c:v>
                  </c:pt>
                  <c:pt idx="3">
                    <c:v>1.7153464077395351E-2</c:v>
                  </c:pt>
                  <c:pt idx="4">
                    <c:v>0.12048624479284359</c:v>
                  </c:pt>
                </c:numCache>
              </c:numRef>
            </c:plus>
            <c:minus>
              <c:numRef>
                <c:f>'CHI4'!$AC$28:$AC$32</c:f>
                <c:numCache>
                  <c:formatCode>General</c:formatCode>
                  <c:ptCount val="5"/>
                  <c:pt idx="0">
                    <c:v>0.12202225833420895</c:v>
                  </c:pt>
                  <c:pt idx="1">
                    <c:v>0.14313654394113848</c:v>
                  </c:pt>
                  <c:pt idx="2">
                    <c:v>6.8002353772639676E-2</c:v>
                  </c:pt>
                  <c:pt idx="3">
                    <c:v>1.7153464077395351E-2</c:v>
                  </c:pt>
                  <c:pt idx="4">
                    <c:v>0.12048624479284359</c:v>
                  </c:pt>
                </c:numCache>
              </c:numRef>
            </c:minus>
          </c:errBars>
          <c:cat>
            <c:strRef>
              <c:f>'CHI4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4'!$AB$28:$AB$32</c:f>
              <c:numCache>
                <c:formatCode>0.00</c:formatCode>
                <c:ptCount val="5"/>
                <c:pt idx="0">
                  <c:v>0.32922208165465405</c:v>
                </c:pt>
                <c:pt idx="1">
                  <c:v>0.47239086949626663</c:v>
                </c:pt>
                <c:pt idx="2">
                  <c:v>0.43875712762750796</c:v>
                </c:pt>
                <c:pt idx="3">
                  <c:v>0.17267699666751021</c:v>
                </c:pt>
                <c:pt idx="4">
                  <c:v>0.248002820967963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62EC-44AC-9A87-8BAD77F3B4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0.8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3'!$AC$28:$AC$32</c:f>
                <c:numCache>
                  <c:formatCode>General</c:formatCode>
                  <c:ptCount val="5"/>
                  <c:pt idx="0">
                    <c:v>1.4534955861605596E-2</c:v>
                  </c:pt>
                  <c:pt idx="1">
                    <c:v>2.0505185043019795E-2</c:v>
                  </c:pt>
                  <c:pt idx="2">
                    <c:v>3.0731057397943008E-2</c:v>
                  </c:pt>
                  <c:pt idx="3">
                    <c:v>4.445147604516736E-4</c:v>
                  </c:pt>
                  <c:pt idx="4">
                    <c:v>3.8260153788258308E-3</c:v>
                  </c:pt>
                </c:numCache>
              </c:numRef>
            </c:plus>
            <c:minus>
              <c:numRef>
                <c:f>'CHI3'!$AC$28:$AC$32</c:f>
                <c:numCache>
                  <c:formatCode>General</c:formatCode>
                  <c:ptCount val="5"/>
                  <c:pt idx="0">
                    <c:v>1.4534955861605596E-2</c:v>
                  </c:pt>
                  <c:pt idx="1">
                    <c:v>2.0505185043019795E-2</c:v>
                  </c:pt>
                  <c:pt idx="2">
                    <c:v>3.0731057397943008E-2</c:v>
                  </c:pt>
                  <c:pt idx="3">
                    <c:v>4.445147604516736E-4</c:v>
                  </c:pt>
                  <c:pt idx="4">
                    <c:v>3.8260153788258308E-3</c:v>
                  </c:pt>
                </c:numCache>
              </c:numRef>
            </c:minus>
          </c:errBars>
          <c:cat>
            <c:strRef>
              <c:f>'CHI3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3'!$AB$28:$AB$32</c:f>
              <c:numCache>
                <c:formatCode>0.00</c:formatCode>
                <c:ptCount val="5"/>
                <c:pt idx="0">
                  <c:v>4.8546362250779927E-2</c:v>
                </c:pt>
                <c:pt idx="1">
                  <c:v>0.11429293920969806</c:v>
                </c:pt>
                <c:pt idx="2">
                  <c:v>6.1349168271781426E-2</c:v>
                </c:pt>
                <c:pt idx="3">
                  <c:v>3.4676986065795092E-2</c:v>
                </c:pt>
                <c:pt idx="4">
                  <c:v>3.1687674914783005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7CD0-4370-9E6C-97160EC5FB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2'!$AC$28:$AC$32</c:f>
                <c:numCache>
                  <c:formatCode>General</c:formatCode>
                  <c:ptCount val="5"/>
                  <c:pt idx="0">
                    <c:v>3.8489469852923418E-2</c:v>
                  </c:pt>
                  <c:pt idx="1">
                    <c:v>6.5132170771733569E-2</c:v>
                  </c:pt>
                  <c:pt idx="2">
                    <c:v>3.3770636808049058E-2</c:v>
                  </c:pt>
                  <c:pt idx="3">
                    <c:v>1.0767622707463089E-2</c:v>
                  </c:pt>
                  <c:pt idx="4">
                    <c:v>1.1898064615110445E-2</c:v>
                  </c:pt>
                </c:numCache>
              </c:numRef>
            </c:plus>
            <c:minus>
              <c:numRef>
                <c:f>'CHI2'!$AC$28:$AC$32</c:f>
                <c:numCache>
                  <c:formatCode>General</c:formatCode>
                  <c:ptCount val="5"/>
                  <c:pt idx="0">
                    <c:v>3.8489469852923418E-2</c:v>
                  </c:pt>
                  <c:pt idx="1">
                    <c:v>6.5132170771733569E-2</c:v>
                  </c:pt>
                  <c:pt idx="2">
                    <c:v>3.3770636808049058E-2</c:v>
                  </c:pt>
                  <c:pt idx="3">
                    <c:v>1.0767622707463089E-2</c:v>
                  </c:pt>
                  <c:pt idx="4">
                    <c:v>1.1898064615110445E-2</c:v>
                  </c:pt>
                </c:numCache>
              </c:numRef>
            </c:minus>
          </c:errBars>
          <c:cat>
            <c:strRef>
              <c:f>'CHI2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2'!$AB$28:$AB$32</c:f>
              <c:numCache>
                <c:formatCode>0.00</c:formatCode>
                <c:ptCount val="5"/>
                <c:pt idx="0">
                  <c:v>6.9416130187630376E-2</c:v>
                </c:pt>
                <c:pt idx="1">
                  <c:v>9.9442631605903539E-2</c:v>
                </c:pt>
                <c:pt idx="2">
                  <c:v>6.0508017075699437E-2</c:v>
                </c:pt>
                <c:pt idx="3">
                  <c:v>3.767284577615513E-2</c:v>
                </c:pt>
                <c:pt idx="4">
                  <c:v>3.3668354489473425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89B3-4A68-A04C-DC00AC2EB1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1'!$AC$28:$AC$32</c:f>
                <c:numCache>
                  <c:formatCode>General</c:formatCode>
                  <c:ptCount val="5"/>
                  <c:pt idx="0">
                    <c:v>2.6358981289535638E-3</c:v>
                  </c:pt>
                  <c:pt idx="1">
                    <c:v>4.7276829958371354E-2</c:v>
                  </c:pt>
                  <c:pt idx="2">
                    <c:v>7.1948306079434449E-2</c:v>
                  </c:pt>
                  <c:pt idx="3">
                    <c:v>5.4137814291143956E-2</c:v>
                  </c:pt>
                  <c:pt idx="4">
                    <c:v>4.1788524065886561E-2</c:v>
                  </c:pt>
                </c:numCache>
              </c:numRef>
            </c:plus>
            <c:minus>
              <c:numRef>
                <c:f>'CHI1'!$AC$28:$AC$32</c:f>
                <c:numCache>
                  <c:formatCode>General</c:formatCode>
                  <c:ptCount val="5"/>
                  <c:pt idx="0">
                    <c:v>2.6358981289535638E-3</c:v>
                  </c:pt>
                  <c:pt idx="1">
                    <c:v>4.7276829958371354E-2</c:v>
                  </c:pt>
                  <c:pt idx="2">
                    <c:v>7.1948306079434449E-2</c:v>
                  </c:pt>
                  <c:pt idx="3">
                    <c:v>5.4137814291143956E-2</c:v>
                  </c:pt>
                  <c:pt idx="4">
                    <c:v>4.1788524065886561E-2</c:v>
                  </c:pt>
                </c:numCache>
              </c:numRef>
            </c:minus>
          </c:errBars>
          <c:cat>
            <c:strRef>
              <c:f>'CHI1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1'!$AB$28:$AB$32</c:f>
              <c:numCache>
                <c:formatCode>0.00</c:formatCode>
                <c:ptCount val="5"/>
                <c:pt idx="0">
                  <c:v>0.44184913988629237</c:v>
                </c:pt>
                <c:pt idx="1">
                  <c:v>0.38209021078570227</c:v>
                </c:pt>
                <c:pt idx="2">
                  <c:v>0.53964191832783748</c:v>
                </c:pt>
                <c:pt idx="3">
                  <c:v>0.19884777331438067</c:v>
                </c:pt>
                <c:pt idx="4">
                  <c:v>0.15324409523341015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D787-4724-94D5-090DA0107B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0.8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none"/>
        <c:minorTickMark val="none"/>
        <c:tickLblPos val="nextTo"/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none"/>
        <c:minorTickMark val="none"/>
        <c:tickLblPos val="nextTo"/>
        <c:spPr>
          <a:ln/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6'!$AC$28:$AC$32</c:f>
                <c:numCache>
                  <c:formatCode>General</c:formatCode>
                  <c:ptCount val="5"/>
                  <c:pt idx="0">
                    <c:v>0.11769508808289941</c:v>
                  </c:pt>
                  <c:pt idx="1">
                    <c:v>9.3154404227609303E-2</c:v>
                  </c:pt>
                  <c:pt idx="2">
                    <c:v>0.12589552718050925</c:v>
                  </c:pt>
                  <c:pt idx="3">
                    <c:v>0.11443096349702976</c:v>
                  </c:pt>
                  <c:pt idx="4">
                    <c:v>8.7951681588765498E-2</c:v>
                  </c:pt>
                </c:numCache>
              </c:numRef>
            </c:plus>
            <c:minus>
              <c:numRef>
                <c:f>'CHI6'!$AC$28:$AC$32</c:f>
                <c:numCache>
                  <c:formatCode>General</c:formatCode>
                  <c:ptCount val="5"/>
                  <c:pt idx="0">
                    <c:v>0.11769508808289941</c:v>
                  </c:pt>
                  <c:pt idx="1">
                    <c:v>9.3154404227609303E-2</c:v>
                  </c:pt>
                  <c:pt idx="2">
                    <c:v>0.12589552718050925</c:v>
                  </c:pt>
                  <c:pt idx="3">
                    <c:v>0.11443096349702976</c:v>
                  </c:pt>
                  <c:pt idx="4">
                    <c:v>8.7951681588765498E-2</c:v>
                  </c:pt>
                </c:numCache>
              </c:numRef>
            </c:minus>
          </c:errBars>
          <c:cat>
            <c:strRef>
              <c:f>'CHI6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6'!$AB$28:$AB$32</c:f>
              <c:numCache>
                <c:formatCode>0.00</c:formatCode>
                <c:ptCount val="5"/>
                <c:pt idx="0">
                  <c:v>0.26562891473517386</c:v>
                </c:pt>
                <c:pt idx="1">
                  <c:v>0.3117221323329542</c:v>
                </c:pt>
                <c:pt idx="2">
                  <c:v>0.24765763920156292</c:v>
                </c:pt>
                <c:pt idx="3">
                  <c:v>0.26419994406737174</c:v>
                </c:pt>
                <c:pt idx="4">
                  <c:v>0.17369371339859516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DC3E-45CE-AB20-B2D6ACF655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6'!$AC$29:$AC$34</c:f>
                <c:numCache>
                  <c:formatCode>General</c:formatCode>
                  <c:ptCount val="6"/>
                  <c:pt idx="0">
                    <c:v>9.2346836227165871E-2</c:v>
                  </c:pt>
                  <c:pt idx="1">
                    <c:v>3.9564934505220008E-2</c:v>
                  </c:pt>
                  <c:pt idx="2">
                    <c:v>3.1406932300036008E-2</c:v>
                  </c:pt>
                  <c:pt idx="3">
                    <c:v>8.4896702906506569E-2</c:v>
                  </c:pt>
                  <c:pt idx="4">
                    <c:v>3.1706053993147652E-2</c:v>
                  </c:pt>
                  <c:pt idx="5">
                    <c:v>1.3753285532108001E-2</c:v>
                  </c:pt>
                </c:numCache>
              </c:numRef>
            </c:plus>
            <c:minus>
              <c:numRef>
                <c:f>'CHI6'!$AC$29:$AC$34</c:f>
                <c:numCache>
                  <c:formatCode>General</c:formatCode>
                  <c:ptCount val="6"/>
                  <c:pt idx="0">
                    <c:v>9.2346836227165871E-2</c:v>
                  </c:pt>
                  <c:pt idx="1">
                    <c:v>3.9564934505220008E-2</c:v>
                  </c:pt>
                  <c:pt idx="2">
                    <c:v>3.1406932300036008E-2</c:v>
                  </c:pt>
                  <c:pt idx="3">
                    <c:v>8.4896702906506569E-2</c:v>
                  </c:pt>
                  <c:pt idx="4">
                    <c:v>3.1706053993147652E-2</c:v>
                  </c:pt>
                  <c:pt idx="5">
                    <c:v>1.3753285532108001E-2</c:v>
                  </c:pt>
                </c:numCache>
              </c:numRef>
            </c:minus>
          </c:errBars>
          <c:cat>
            <c:numRef>
              <c:f>'CHI6'!$AA$29:$AA$34</c:f>
              <c:numCache>
                <c:formatCode>General</c:formatCode>
                <c:ptCount val="6"/>
              </c:numCache>
            </c:numRef>
          </c:cat>
          <c:val>
            <c:numRef>
              <c:f>'CHI6'!$AB$29:$AB$34</c:f>
              <c:numCache>
                <c:formatCode>0.00</c:formatCode>
                <c:ptCount val="6"/>
                <c:pt idx="0">
                  <c:v>0.20789752051707508</c:v>
                </c:pt>
                <c:pt idx="1">
                  <c:v>0.19468737361283589</c:v>
                </c:pt>
                <c:pt idx="2">
                  <c:v>0.50619977388004644</c:v>
                </c:pt>
                <c:pt idx="3">
                  <c:v>0.28698111255640635</c:v>
                </c:pt>
                <c:pt idx="4">
                  <c:v>0.59921320805816114</c:v>
                </c:pt>
                <c:pt idx="5">
                  <c:v>3.6066600025652415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F0B2-4DA7-9D72-A914A15E3A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1.5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  <c:majorUnit val="0.30000000000000004"/>
      </c:valAx>
    </c:plotArea>
    <c:plotVisOnly val="1"/>
    <c:dispBlanksAs val="zero"/>
    <c:showDLblsOverMax val="1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2'!$AC$29:$AC$34</c:f>
                <c:numCache>
                  <c:formatCode>General</c:formatCode>
                  <c:ptCount val="6"/>
                  <c:pt idx="0">
                    <c:v>1.1330069335999782E-2</c:v>
                  </c:pt>
                  <c:pt idx="1">
                    <c:v>6.5936180580544431E-3</c:v>
                  </c:pt>
                  <c:pt idx="2">
                    <c:v>1.1428443923172004E-2</c:v>
                  </c:pt>
                  <c:pt idx="3">
                    <c:v>9.095962842230354E-3</c:v>
                  </c:pt>
                  <c:pt idx="4">
                    <c:v>6.9338376588097255E-3</c:v>
                  </c:pt>
                  <c:pt idx="5">
                    <c:v>2.1458852619701284E-2</c:v>
                  </c:pt>
                </c:numCache>
              </c:numRef>
            </c:plus>
            <c:minus>
              <c:numRef>
                <c:f>'CHI2'!$AC$29:$AC$34</c:f>
                <c:numCache>
                  <c:formatCode>General</c:formatCode>
                  <c:ptCount val="6"/>
                  <c:pt idx="0">
                    <c:v>1.1330069335999782E-2</c:v>
                  </c:pt>
                  <c:pt idx="1">
                    <c:v>6.5936180580544431E-3</c:v>
                  </c:pt>
                  <c:pt idx="2">
                    <c:v>1.1428443923172004E-2</c:v>
                  </c:pt>
                  <c:pt idx="3">
                    <c:v>9.095962842230354E-3</c:v>
                  </c:pt>
                  <c:pt idx="4">
                    <c:v>6.9338376588097255E-3</c:v>
                  </c:pt>
                  <c:pt idx="5">
                    <c:v>2.1458852619701284E-2</c:v>
                  </c:pt>
                </c:numCache>
              </c:numRef>
            </c:minus>
          </c:errBars>
          <c:cat>
            <c:numRef>
              <c:f>'CHI2'!$AA$29:$AA$34</c:f>
              <c:numCache>
                <c:formatCode>General</c:formatCode>
                <c:ptCount val="6"/>
              </c:numCache>
            </c:numRef>
          </c:cat>
          <c:val>
            <c:numRef>
              <c:f>'CHI2'!$AB$29:$AB$34</c:f>
              <c:numCache>
                <c:formatCode>0.00</c:formatCode>
                <c:ptCount val="6"/>
                <c:pt idx="0">
                  <c:v>2.7466798925695073E-2</c:v>
                </c:pt>
                <c:pt idx="1">
                  <c:v>2.1810764169121626E-2</c:v>
                </c:pt>
                <c:pt idx="2">
                  <c:v>3.5988372203867448E-2</c:v>
                </c:pt>
                <c:pt idx="3">
                  <c:v>2.8942434045900838E-2</c:v>
                </c:pt>
                <c:pt idx="4">
                  <c:v>4.2979189557419875E-2</c:v>
                </c:pt>
                <c:pt idx="5">
                  <c:v>5.7232739629642954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E1FB-4D3E-9389-B4A1592E3B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3'!$AC$29:$AC$34</c:f>
                <c:numCache>
                  <c:formatCode>General</c:formatCode>
                  <c:ptCount val="6"/>
                  <c:pt idx="0">
                    <c:v>1.4527669703664316E-2</c:v>
                  </c:pt>
                  <c:pt idx="1">
                    <c:v>1.622000011289396E-2</c:v>
                  </c:pt>
                  <c:pt idx="2">
                    <c:v>8.1999615800554718E-2</c:v>
                  </c:pt>
                  <c:pt idx="3">
                    <c:v>2.39184497188757E-2</c:v>
                  </c:pt>
                  <c:pt idx="4">
                    <c:v>6.454583670499503E-2</c:v>
                  </c:pt>
                  <c:pt idx="5">
                    <c:v>7.0429244682914619E-3</c:v>
                  </c:pt>
                </c:numCache>
              </c:numRef>
            </c:plus>
            <c:minus>
              <c:numRef>
                <c:f>'CHI3'!$AC$29:$AC$34</c:f>
                <c:numCache>
                  <c:formatCode>General</c:formatCode>
                  <c:ptCount val="6"/>
                  <c:pt idx="0">
                    <c:v>1.4527669703664316E-2</c:v>
                  </c:pt>
                  <c:pt idx="1">
                    <c:v>1.622000011289396E-2</c:v>
                  </c:pt>
                  <c:pt idx="2">
                    <c:v>8.1999615800554718E-2</c:v>
                  </c:pt>
                  <c:pt idx="3">
                    <c:v>2.39184497188757E-2</c:v>
                  </c:pt>
                  <c:pt idx="4">
                    <c:v>6.454583670499503E-2</c:v>
                  </c:pt>
                  <c:pt idx="5">
                    <c:v>7.0429244682914619E-3</c:v>
                  </c:pt>
                </c:numCache>
              </c:numRef>
            </c:minus>
          </c:errBars>
          <c:cat>
            <c:numRef>
              <c:f>'CHI3'!$AA$29:$AA$34</c:f>
              <c:numCache>
                <c:formatCode>General</c:formatCode>
                <c:ptCount val="6"/>
              </c:numCache>
            </c:numRef>
          </c:cat>
          <c:val>
            <c:numRef>
              <c:f>'CHI3'!$AB$29:$AB$34</c:f>
              <c:numCache>
                <c:formatCode>0.00</c:formatCode>
                <c:ptCount val="6"/>
                <c:pt idx="0">
                  <c:v>7.0368821133585946E-2</c:v>
                </c:pt>
                <c:pt idx="1">
                  <c:v>4.8943596713493E-2</c:v>
                </c:pt>
                <c:pt idx="2">
                  <c:v>0.30512686758741608</c:v>
                </c:pt>
                <c:pt idx="3">
                  <c:v>4.7079071922508313E-2</c:v>
                </c:pt>
                <c:pt idx="4">
                  <c:v>0.15818781642087126</c:v>
                </c:pt>
                <c:pt idx="5">
                  <c:v>1.0695704950474793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9890-4D07-BA05-1989A462F4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0.60000000000000009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4'!$AC$29:$AC$34</c:f>
                <c:numCache>
                  <c:formatCode>General</c:formatCode>
                  <c:ptCount val="6"/>
                  <c:pt idx="0">
                    <c:v>3.6931538718527133E-2</c:v>
                  </c:pt>
                  <c:pt idx="1">
                    <c:v>7.3208568541605679E-2</c:v>
                  </c:pt>
                  <c:pt idx="2">
                    <c:v>0.14305797744205004</c:v>
                  </c:pt>
                  <c:pt idx="3">
                    <c:v>3.1325815553813426E-2</c:v>
                  </c:pt>
                  <c:pt idx="4">
                    <c:v>9.1556284012861963E-2</c:v>
                  </c:pt>
                  <c:pt idx="5">
                    <c:v>7.1523429524039802E-3</c:v>
                  </c:pt>
                </c:numCache>
              </c:numRef>
            </c:plus>
            <c:minus>
              <c:numRef>
                <c:f>'CHI4'!$AC$29:$AC$34</c:f>
                <c:numCache>
                  <c:formatCode>General</c:formatCode>
                  <c:ptCount val="6"/>
                  <c:pt idx="0">
                    <c:v>3.6931538718527133E-2</c:v>
                  </c:pt>
                  <c:pt idx="1">
                    <c:v>7.3208568541605679E-2</c:v>
                  </c:pt>
                  <c:pt idx="2">
                    <c:v>0.14305797744205004</c:v>
                  </c:pt>
                  <c:pt idx="3">
                    <c:v>3.1325815553813426E-2</c:v>
                  </c:pt>
                  <c:pt idx="4">
                    <c:v>9.1556284012861963E-2</c:v>
                  </c:pt>
                  <c:pt idx="5">
                    <c:v>7.1523429524039802E-3</c:v>
                  </c:pt>
                </c:numCache>
              </c:numRef>
            </c:minus>
          </c:errBars>
          <c:cat>
            <c:numRef>
              <c:f>'CHI4'!$AA$29:$AA$34</c:f>
              <c:numCache>
                <c:formatCode>General</c:formatCode>
                <c:ptCount val="6"/>
              </c:numCache>
            </c:numRef>
          </c:cat>
          <c:val>
            <c:numRef>
              <c:f>'CHI4'!$AB$29:$AB$34</c:f>
              <c:numCache>
                <c:formatCode>0.00</c:formatCode>
                <c:ptCount val="6"/>
                <c:pt idx="0">
                  <c:v>0.19699030002307319</c:v>
                </c:pt>
                <c:pt idx="1">
                  <c:v>0.16491737851669885</c:v>
                </c:pt>
                <c:pt idx="2">
                  <c:v>0.48553260954960192</c:v>
                </c:pt>
                <c:pt idx="3">
                  <c:v>9.4857349324107706E-2</c:v>
                </c:pt>
                <c:pt idx="4">
                  <c:v>0.31590555915228002</c:v>
                </c:pt>
                <c:pt idx="5">
                  <c:v>1.6380257066511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E6C1-4243-81AE-52E9AE15BB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1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5'!$AC$29:$AC$34</c:f>
                <c:numCache>
                  <c:formatCode>General</c:formatCode>
                  <c:ptCount val="6"/>
                  <c:pt idx="0">
                    <c:v>2.0107462506377991E-2</c:v>
                  </c:pt>
                  <c:pt idx="1">
                    <c:v>4.0200754465867072E-2</c:v>
                  </c:pt>
                  <c:pt idx="2">
                    <c:v>0.10500476431756373</c:v>
                  </c:pt>
                  <c:pt idx="3">
                    <c:v>5.6052220905413855E-2</c:v>
                  </c:pt>
                  <c:pt idx="4">
                    <c:v>0.16875490571657198</c:v>
                  </c:pt>
                  <c:pt idx="5">
                    <c:v>2.7767135726746876E-2</c:v>
                  </c:pt>
                </c:numCache>
              </c:numRef>
            </c:plus>
            <c:minus>
              <c:numRef>
                <c:f>'CHI5'!$AC$29:$AC$34</c:f>
                <c:numCache>
                  <c:formatCode>General</c:formatCode>
                  <c:ptCount val="6"/>
                  <c:pt idx="0">
                    <c:v>2.0107462506377991E-2</c:v>
                  </c:pt>
                  <c:pt idx="1">
                    <c:v>4.0200754465867072E-2</c:v>
                  </c:pt>
                  <c:pt idx="2">
                    <c:v>0.10500476431756373</c:v>
                  </c:pt>
                  <c:pt idx="3">
                    <c:v>5.6052220905413855E-2</c:v>
                  </c:pt>
                  <c:pt idx="4">
                    <c:v>0.16875490571657198</c:v>
                  </c:pt>
                  <c:pt idx="5">
                    <c:v>2.7767135726746876E-2</c:v>
                  </c:pt>
                </c:numCache>
              </c:numRef>
            </c:minus>
          </c:errBars>
          <c:cat>
            <c:numRef>
              <c:f>'CHI5'!$AA$29:$AA$34</c:f>
              <c:numCache>
                <c:formatCode>General</c:formatCode>
                <c:ptCount val="6"/>
              </c:numCache>
            </c:numRef>
          </c:cat>
          <c:val>
            <c:numRef>
              <c:f>'CHI5'!$AB$29:$AB$34</c:f>
              <c:numCache>
                <c:formatCode>0.00</c:formatCode>
                <c:ptCount val="6"/>
                <c:pt idx="0">
                  <c:v>6.9157215599577479E-2</c:v>
                </c:pt>
                <c:pt idx="1">
                  <c:v>9.7459753634925705E-2</c:v>
                </c:pt>
                <c:pt idx="2">
                  <c:v>0.19218739705819135</c:v>
                </c:pt>
                <c:pt idx="3">
                  <c:v>8.6316431982392181E-2</c:v>
                </c:pt>
                <c:pt idx="4">
                  <c:v>0.3025731728059266</c:v>
                </c:pt>
                <c:pt idx="5">
                  <c:v>5.5035315689238307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48B8-4A7E-9124-5A88F43ED2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1'!$AC$29:$AC$34</c:f>
                <c:numCache>
                  <c:formatCode>General</c:formatCode>
                  <c:ptCount val="6"/>
                  <c:pt idx="0">
                    <c:v>1.8003195826091743E-2</c:v>
                  </c:pt>
                  <c:pt idx="1">
                    <c:v>5.6465484011048381E-2</c:v>
                  </c:pt>
                  <c:pt idx="2">
                    <c:v>0.13365138906571422</c:v>
                  </c:pt>
                  <c:pt idx="3">
                    <c:v>8.856742652631644E-2</c:v>
                  </c:pt>
                  <c:pt idx="4">
                    <c:v>4.8046684777698578E-2</c:v>
                  </c:pt>
                  <c:pt idx="5">
                    <c:v>2.6690630002986347E-2</c:v>
                  </c:pt>
                </c:numCache>
              </c:numRef>
            </c:plus>
            <c:minus>
              <c:numRef>
                <c:f>'CHI1'!$AC$29:$AC$34</c:f>
                <c:numCache>
                  <c:formatCode>General</c:formatCode>
                  <c:ptCount val="6"/>
                  <c:pt idx="0">
                    <c:v>1.8003195826091743E-2</c:v>
                  </c:pt>
                  <c:pt idx="1">
                    <c:v>5.6465484011048381E-2</c:v>
                  </c:pt>
                  <c:pt idx="2">
                    <c:v>0.13365138906571422</c:v>
                  </c:pt>
                  <c:pt idx="3">
                    <c:v>8.856742652631644E-2</c:v>
                  </c:pt>
                  <c:pt idx="4">
                    <c:v>4.8046684777698578E-2</c:v>
                  </c:pt>
                  <c:pt idx="5">
                    <c:v>2.6690630002986347E-2</c:v>
                  </c:pt>
                </c:numCache>
              </c:numRef>
            </c:minus>
          </c:errBars>
          <c:cat>
            <c:numRef>
              <c:f>'CHI1'!$AA$29:$AA$34</c:f>
              <c:numCache>
                <c:formatCode>General</c:formatCode>
                <c:ptCount val="6"/>
              </c:numCache>
            </c:numRef>
          </c:cat>
          <c:val>
            <c:numRef>
              <c:f>'CHI1'!$AB$29:$AB$34</c:f>
              <c:numCache>
                <c:formatCode>0.00</c:formatCode>
                <c:ptCount val="6"/>
                <c:pt idx="0">
                  <c:v>0.16047422480904155</c:v>
                </c:pt>
                <c:pt idx="1">
                  <c:v>0.18776527449091854</c:v>
                </c:pt>
                <c:pt idx="2">
                  <c:v>0.46307647120674139</c:v>
                </c:pt>
                <c:pt idx="3">
                  <c:v>0.21152009765717172</c:v>
                </c:pt>
                <c:pt idx="4">
                  <c:v>0.22963923587055762</c:v>
                </c:pt>
                <c:pt idx="5">
                  <c:v>6.4992023398571824E-2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DBF8-405E-9FA0-893C0CFBF2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b="0">
                <a:solidFill>
                  <a:srgbClr val="000000"/>
                </a:solidFill>
                <a:latin typeface="+mn-lt"/>
              </a:defRPr>
            </a:pPr>
            <a:endParaRPr lang="en-US"/>
          </a:p>
        </c:tx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1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title>
          <c:tx>
            <c:rich>
              <a:bodyPr/>
              <a:lstStyle/>
              <a:p>
                <a:pPr lvl="0">
                  <a:defRPr b="0">
                    <a:solidFill>
                      <a:srgbClr val="000000"/>
                    </a:solidFill>
                    <a:latin typeface="+mn-lt"/>
                  </a:defRPr>
                </a:pPr>
                <a:endParaRPr lang="x-none"/>
              </a:p>
            </c:rich>
          </c:tx>
          <c:overlay val="0"/>
        </c:title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 lvl="0">
              <a:defRPr sz="900" b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84052992"/>
        <c:crosses val="autoZero"/>
        <c:crossBetween val="between"/>
      </c:valAx>
    </c:plotArea>
    <c:plotVisOnly val="1"/>
    <c:dispBlanksAs val="zero"/>
    <c:showDLblsOverMax val="1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7'!$AC$28:$AC$32</c:f>
                <c:numCache>
                  <c:formatCode>General</c:formatCode>
                  <c:ptCount val="5"/>
                  <c:pt idx="0">
                    <c:v>0.13272310463157713</c:v>
                  </c:pt>
                  <c:pt idx="1">
                    <c:v>8.769637234186288E-2</c:v>
                  </c:pt>
                  <c:pt idx="2">
                    <c:v>0.16114482217838066</c:v>
                  </c:pt>
                  <c:pt idx="3">
                    <c:v>8.6757622886674615E-2</c:v>
                  </c:pt>
                  <c:pt idx="4">
                    <c:v>0.15786002495566506</c:v>
                  </c:pt>
                </c:numCache>
              </c:numRef>
            </c:plus>
            <c:minus>
              <c:numRef>
                <c:f>'CHI7'!$AC$28:$AC$32</c:f>
                <c:numCache>
                  <c:formatCode>General</c:formatCode>
                  <c:ptCount val="5"/>
                  <c:pt idx="0">
                    <c:v>0.13272310463157713</c:v>
                  </c:pt>
                  <c:pt idx="1">
                    <c:v>8.769637234186288E-2</c:v>
                  </c:pt>
                  <c:pt idx="2">
                    <c:v>0.16114482217838066</c:v>
                  </c:pt>
                  <c:pt idx="3">
                    <c:v>8.6757622886674615E-2</c:v>
                  </c:pt>
                  <c:pt idx="4">
                    <c:v>0.15786002495566506</c:v>
                  </c:pt>
                </c:numCache>
              </c:numRef>
            </c:minus>
          </c:errBars>
          <c:cat>
            <c:strRef>
              <c:f>'CHI7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7'!$AB$28:$AB$32</c:f>
              <c:numCache>
                <c:formatCode>0.00</c:formatCode>
                <c:ptCount val="5"/>
                <c:pt idx="0">
                  <c:v>0.33068587433966273</c:v>
                </c:pt>
                <c:pt idx="1">
                  <c:v>0.34306657982483535</c:v>
                </c:pt>
                <c:pt idx="2">
                  <c:v>0.28468585801074281</c:v>
                </c:pt>
                <c:pt idx="3">
                  <c:v>0.22274676377228608</c:v>
                </c:pt>
                <c:pt idx="4">
                  <c:v>0.2692231874101586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1512-4CB3-8B6C-CE7CA9FC4C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1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1"/>
        <c:ser>
          <c:idx val="0"/>
          <c:order val="0"/>
          <c:spPr>
            <a:solidFill>
              <a:srgbClr val="000000"/>
            </a:solidFill>
          </c:spPr>
          <c:invertIfNegative val="1"/>
          <c:errBars>
            <c:errBarType val="both"/>
            <c:errValType val="cust"/>
            <c:noEndCap val="0"/>
            <c:plus>
              <c:numRef>
                <c:f>'CHI5'!$AC$28:$AC$32</c:f>
                <c:numCache>
                  <c:formatCode>General</c:formatCode>
                  <c:ptCount val="5"/>
                  <c:pt idx="0">
                    <c:v>9.8189752136019257E-2</c:v>
                  </c:pt>
                  <c:pt idx="1">
                    <c:v>9.3221364352809269E-2</c:v>
                  </c:pt>
                  <c:pt idx="2">
                    <c:v>0.12466530164238215</c:v>
                  </c:pt>
                  <c:pt idx="3">
                    <c:v>3.7581373614684006E-2</c:v>
                  </c:pt>
                  <c:pt idx="4">
                    <c:v>5.7665975749001883E-2</c:v>
                  </c:pt>
                </c:numCache>
              </c:numRef>
            </c:plus>
            <c:minus>
              <c:numRef>
                <c:f>'CHI5'!$AC$28:$AC$32</c:f>
                <c:numCache>
                  <c:formatCode>General</c:formatCode>
                  <c:ptCount val="5"/>
                  <c:pt idx="0">
                    <c:v>9.8189752136019257E-2</c:v>
                  </c:pt>
                  <c:pt idx="1">
                    <c:v>9.3221364352809269E-2</c:v>
                  </c:pt>
                  <c:pt idx="2">
                    <c:v>0.12466530164238215</c:v>
                  </c:pt>
                  <c:pt idx="3">
                    <c:v>3.7581373614684006E-2</c:v>
                  </c:pt>
                  <c:pt idx="4">
                    <c:v>5.7665975749001883E-2</c:v>
                  </c:pt>
                </c:numCache>
              </c:numRef>
            </c:minus>
          </c:errBars>
          <c:cat>
            <c:strRef>
              <c:f>'CHI5'!$AA$28:$AA$32</c:f>
              <c:strCache>
                <c:ptCount val="5"/>
                <c:pt idx="0">
                  <c:v>0 h</c:v>
                </c:pt>
                <c:pt idx="1">
                  <c:v>1 h</c:v>
                </c:pt>
                <c:pt idx="2">
                  <c:v>12 h</c:v>
                </c:pt>
                <c:pt idx="3">
                  <c:v>24 h</c:v>
                </c:pt>
                <c:pt idx="4">
                  <c:v>48 h</c:v>
                </c:pt>
              </c:strCache>
            </c:strRef>
          </c:cat>
          <c:val>
            <c:numRef>
              <c:f>'CHI5'!$AB$28:$AB$32</c:f>
              <c:numCache>
                <c:formatCode>0.00</c:formatCode>
                <c:ptCount val="5"/>
                <c:pt idx="0">
                  <c:v>0.17647330437534145</c:v>
                </c:pt>
                <c:pt idx="1">
                  <c:v>0.21470942222933878</c:v>
                </c:pt>
                <c:pt idx="2">
                  <c:v>0.20228512380157357</c:v>
                </c:pt>
                <c:pt idx="3">
                  <c:v>0.11067286017480622</c:v>
                </c:pt>
                <c:pt idx="4">
                  <c:v>0.12035884454425196</c:v>
                </c:pt>
              </c:numCache>
            </c:numRef>
          </c:val>
          <c:extLst>
            <c:ext xmlns:c14="http://schemas.microsoft.com/office/drawing/2007/8/2/chart" uri="{6F2FDCE9-48DA-4B69-8628-5D25D57E5C99}">
              <c14:invertSolidFillFmt>
                <c14:spPr xmlns:c14="http://schemas.microsoft.com/office/drawing/2007/8/2/chart">
                  <a:solidFill>
                    <a:srgbClr val="FFFFFF"/>
                  </a:solidFill>
                </c14:spPr>
              </c14:invertSolidFillFmt>
            </c:ext>
            <c:ext xmlns:c16="http://schemas.microsoft.com/office/drawing/2014/chart" uri="{C3380CC4-5D6E-409C-BE32-E72D297353CC}">
              <c16:uniqueId val="{00000000-0E1F-4D64-BE66-81A29A180F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84052992"/>
        <c:axId val="84055168"/>
      </c:barChart>
      <c:catAx>
        <c:axId val="840529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endParaRPr lang="x-none"/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5168"/>
        <c:crosses val="autoZero"/>
        <c:auto val="1"/>
        <c:lblAlgn val="ctr"/>
        <c:lblOffset val="100"/>
        <c:noMultiLvlLbl val="1"/>
      </c:catAx>
      <c:valAx>
        <c:axId val="84055168"/>
        <c:scaling>
          <c:orientation val="minMax"/>
          <c:max val="0.4"/>
        </c:scaling>
        <c:delete val="0"/>
        <c:axPos val="l"/>
        <c:majorGridlines>
          <c:spPr>
            <a:ln>
              <a:noFill/>
            </a:ln>
          </c:spPr>
        </c:majorGridlines>
        <c:minorGridlines>
          <c:spPr>
            <a:ln>
              <a:solidFill>
                <a:srgbClr val="CCCCCC">
                  <a:alpha val="0"/>
                </a:srgbClr>
              </a:solidFill>
            </a:ln>
          </c:spPr>
        </c:minorGridlines>
        <c:numFmt formatCode="0.00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4052992"/>
        <c:crosses val="autoZero"/>
        <c:crossBetween val="between"/>
      </c:valAx>
    </c:plotArea>
    <c:plotVisOnly val="1"/>
    <c:dispBlanksAs val="zero"/>
    <c:showDLblsOverMax val="1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AD6E2C-7608-482B-B062-F3EEF6C23DB2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22B0B6-29CF-4143-B2BA-E0769732C1D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81571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884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37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172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21430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8072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41662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787822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0456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130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989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890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3DBA2E-AACF-4358-84C9-A1D874DB1F91}" type="datetimeFigureOut">
              <a:rPr lang="ko-KR" altLang="en-US" smtClean="0"/>
              <a:t>2021-09-2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937748-3191-4102-B820-9AEEE9182D7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6207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microsoft.com/office/2007/relationships/hdphoto" Target="../media/hdphoto2.wdp"/><Relationship Id="rId4" Type="http://schemas.openxmlformats.org/officeDocument/2006/relationships/image" Target="../media/image4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wmf"/><Relationship Id="rId2" Type="http://schemas.openxmlformats.org/officeDocument/2006/relationships/image" Target="../media/image17.wm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4.xml"/><Relationship Id="rId3" Type="http://schemas.openxmlformats.org/officeDocument/2006/relationships/chart" Target="../charts/chart9.xml"/><Relationship Id="rId7" Type="http://schemas.openxmlformats.org/officeDocument/2006/relationships/chart" Target="../charts/chart13.xml"/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2.xml"/><Relationship Id="rId5" Type="http://schemas.openxmlformats.org/officeDocument/2006/relationships/chart" Target="../charts/chart11.xml"/><Relationship Id="rId4" Type="http://schemas.openxmlformats.org/officeDocument/2006/relationships/chart" Target="../charts/chart10.xml"/><Relationship Id="rId9" Type="http://schemas.openxmlformats.org/officeDocument/2006/relationships/chart" Target="../charts/char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473" y="553641"/>
            <a:ext cx="6052615" cy="7857780"/>
          </a:xfrm>
          <a:prstGeom prst="rect">
            <a:avLst/>
          </a:prstGeom>
        </p:spPr>
      </p:pic>
      <p:sp>
        <p:nvSpPr>
          <p:cNvPr id="8" name="타원 7"/>
          <p:cNvSpPr/>
          <p:nvPr/>
        </p:nvSpPr>
        <p:spPr>
          <a:xfrm>
            <a:off x="4232205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타원 8"/>
          <p:cNvSpPr/>
          <p:nvPr/>
        </p:nvSpPr>
        <p:spPr>
          <a:xfrm>
            <a:off x="4294152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1" name="타원 10"/>
          <p:cNvSpPr/>
          <p:nvPr/>
        </p:nvSpPr>
        <p:spPr>
          <a:xfrm>
            <a:off x="4394917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2" name="타원 11"/>
          <p:cNvSpPr/>
          <p:nvPr/>
        </p:nvSpPr>
        <p:spPr>
          <a:xfrm>
            <a:off x="4871972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3" name="타원 12"/>
          <p:cNvSpPr/>
          <p:nvPr/>
        </p:nvSpPr>
        <p:spPr>
          <a:xfrm>
            <a:off x="4929156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4" name="타원 13"/>
          <p:cNvSpPr/>
          <p:nvPr/>
        </p:nvSpPr>
        <p:spPr>
          <a:xfrm>
            <a:off x="5034687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9" name="타원 18"/>
          <p:cNvSpPr/>
          <p:nvPr/>
        </p:nvSpPr>
        <p:spPr>
          <a:xfrm>
            <a:off x="4504451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013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맑은 고딕" panose="020B0503020000020004" pitchFamily="50" charset="-127"/>
                <a:cs typeface="+mn-cs"/>
              </a:rPr>
              <a:t>.</a:t>
            </a:r>
            <a:endParaRPr kumimoji="0" lang="ko-KR" altLang="en-US" sz="1013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1" name="타원 20"/>
          <p:cNvSpPr/>
          <p:nvPr/>
        </p:nvSpPr>
        <p:spPr>
          <a:xfrm>
            <a:off x="4766391" y="6012143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7" name="이등변 삼각형 26"/>
          <p:cNvSpPr/>
          <p:nvPr/>
        </p:nvSpPr>
        <p:spPr>
          <a:xfrm>
            <a:off x="4929156" y="5946130"/>
            <a:ext cx="43200" cy="432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5" name="오른쪽 대괄호 14">
            <a:extLst>
              <a:ext uri="{FF2B5EF4-FFF2-40B4-BE49-F238E27FC236}">
                <a16:creationId xmlns:a16="http://schemas.microsoft.com/office/drawing/2014/main" id="{CC1C977F-E592-430E-BB4C-2B9DF4CA503A}"/>
              </a:ext>
            </a:extLst>
          </p:cNvPr>
          <p:cNvSpPr/>
          <p:nvPr/>
        </p:nvSpPr>
        <p:spPr>
          <a:xfrm flipH="1">
            <a:off x="543633" y="789868"/>
            <a:ext cx="54000" cy="820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91B11C-AD2B-4E0E-A668-2355B74F86D3}"/>
              </a:ext>
            </a:extLst>
          </p:cNvPr>
          <p:cNvSpPr txBox="1"/>
          <p:nvPr/>
        </p:nvSpPr>
        <p:spPr>
          <a:xfrm>
            <a:off x="142259" y="1102164"/>
            <a:ext cx="4475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7" name="오른쪽 대괄호 16">
            <a:extLst>
              <a:ext uri="{FF2B5EF4-FFF2-40B4-BE49-F238E27FC236}">
                <a16:creationId xmlns:a16="http://schemas.microsoft.com/office/drawing/2014/main" id="{89C6765F-7510-4B6C-9F05-4E5BF7BFFC07}"/>
              </a:ext>
            </a:extLst>
          </p:cNvPr>
          <p:cNvSpPr/>
          <p:nvPr/>
        </p:nvSpPr>
        <p:spPr>
          <a:xfrm flipH="1">
            <a:off x="543633" y="1639986"/>
            <a:ext cx="54000" cy="396568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92E526-FE4C-42EA-BDCA-4F25E4EE1F12}"/>
              </a:ext>
            </a:extLst>
          </p:cNvPr>
          <p:cNvSpPr txBox="1"/>
          <p:nvPr/>
        </p:nvSpPr>
        <p:spPr>
          <a:xfrm>
            <a:off x="102656" y="1740166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0" name="오른쪽 대괄호 19">
            <a:extLst>
              <a:ext uri="{FF2B5EF4-FFF2-40B4-BE49-F238E27FC236}">
                <a16:creationId xmlns:a16="http://schemas.microsoft.com/office/drawing/2014/main" id="{2C6498A3-8ED2-41D5-A9F2-BA58860ACD2E}"/>
              </a:ext>
            </a:extLst>
          </p:cNvPr>
          <p:cNvSpPr/>
          <p:nvPr/>
        </p:nvSpPr>
        <p:spPr>
          <a:xfrm flipH="1">
            <a:off x="543633" y="2805026"/>
            <a:ext cx="54000" cy="298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F39D6E2-7787-4A58-AC18-FF4E65A82D45}"/>
              </a:ext>
            </a:extLst>
          </p:cNvPr>
          <p:cNvSpPr txBox="1"/>
          <p:nvPr/>
        </p:nvSpPr>
        <p:spPr>
          <a:xfrm>
            <a:off x="56302" y="2856322"/>
            <a:ext cx="53352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V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3" name="오른쪽 대괄호 22">
            <a:extLst>
              <a:ext uri="{FF2B5EF4-FFF2-40B4-BE49-F238E27FC236}">
                <a16:creationId xmlns:a16="http://schemas.microsoft.com/office/drawing/2014/main" id="{28A07957-128C-4410-B7A2-CFB2B0C87F93}"/>
              </a:ext>
            </a:extLst>
          </p:cNvPr>
          <p:cNvSpPr/>
          <p:nvPr/>
        </p:nvSpPr>
        <p:spPr>
          <a:xfrm flipH="1">
            <a:off x="543633" y="2063872"/>
            <a:ext cx="54000" cy="7164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1EFF08B-AB3E-4301-9EE4-1A6D593025E2}"/>
              </a:ext>
            </a:extLst>
          </p:cNvPr>
          <p:cNvSpPr txBox="1"/>
          <p:nvPr/>
        </p:nvSpPr>
        <p:spPr>
          <a:xfrm>
            <a:off x="102656" y="2323968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5" name="오른쪽 대괄호 24">
            <a:extLst>
              <a:ext uri="{FF2B5EF4-FFF2-40B4-BE49-F238E27FC236}">
                <a16:creationId xmlns:a16="http://schemas.microsoft.com/office/drawing/2014/main" id="{CC1C977F-E592-430E-BB4C-2B9DF4CA503A}"/>
              </a:ext>
            </a:extLst>
          </p:cNvPr>
          <p:cNvSpPr/>
          <p:nvPr/>
        </p:nvSpPr>
        <p:spPr>
          <a:xfrm flipH="1">
            <a:off x="543633" y="3443147"/>
            <a:ext cx="54000" cy="820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491B11C-AD2B-4E0E-A668-2355B74F86D3}"/>
              </a:ext>
            </a:extLst>
          </p:cNvPr>
          <p:cNvSpPr txBox="1"/>
          <p:nvPr/>
        </p:nvSpPr>
        <p:spPr>
          <a:xfrm>
            <a:off x="142259" y="3755443"/>
            <a:ext cx="4475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8" name="오른쪽 대괄호 27">
            <a:extLst>
              <a:ext uri="{FF2B5EF4-FFF2-40B4-BE49-F238E27FC236}">
                <a16:creationId xmlns:a16="http://schemas.microsoft.com/office/drawing/2014/main" id="{89C6765F-7510-4B6C-9F05-4E5BF7BFFC07}"/>
              </a:ext>
            </a:extLst>
          </p:cNvPr>
          <p:cNvSpPr/>
          <p:nvPr/>
        </p:nvSpPr>
        <p:spPr>
          <a:xfrm flipH="1">
            <a:off x="543633" y="4293265"/>
            <a:ext cx="54000" cy="396568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092E526-FE4C-42EA-BDCA-4F25E4EE1F12}"/>
              </a:ext>
            </a:extLst>
          </p:cNvPr>
          <p:cNvSpPr txBox="1"/>
          <p:nvPr/>
        </p:nvSpPr>
        <p:spPr>
          <a:xfrm>
            <a:off x="102656" y="4393445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0" name="오른쪽 대괄호 29">
            <a:extLst>
              <a:ext uri="{FF2B5EF4-FFF2-40B4-BE49-F238E27FC236}">
                <a16:creationId xmlns:a16="http://schemas.microsoft.com/office/drawing/2014/main" id="{2C6498A3-8ED2-41D5-A9F2-BA58860ACD2E}"/>
              </a:ext>
            </a:extLst>
          </p:cNvPr>
          <p:cNvSpPr/>
          <p:nvPr/>
        </p:nvSpPr>
        <p:spPr>
          <a:xfrm flipH="1">
            <a:off x="543633" y="5458305"/>
            <a:ext cx="54000" cy="298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F39D6E2-7787-4A58-AC18-FF4E65A82D45}"/>
              </a:ext>
            </a:extLst>
          </p:cNvPr>
          <p:cNvSpPr txBox="1"/>
          <p:nvPr/>
        </p:nvSpPr>
        <p:spPr>
          <a:xfrm>
            <a:off x="56302" y="5509601"/>
            <a:ext cx="53352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V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2" name="오른쪽 대괄호 31">
            <a:extLst>
              <a:ext uri="{FF2B5EF4-FFF2-40B4-BE49-F238E27FC236}">
                <a16:creationId xmlns:a16="http://schemas.microsoft.com/office/drawing/2014/main" id="{28A07957-128C-4410-B7A2-CFB2B0C87F93}"/>
              </a:ext>
            </a:extLst>
          </p:cNvPr>
          <p:cNvSpPr/>
          <p:nvPr/>
        </p:nvSpPr>
        <p:spPr>
          <a:xfrm flipH="1">
            <a:off x="543633" y="4717151"/>
            <a:ext cx="54000" cy="7164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1EFF08B-AB3E-4301-9EE4-1A6D593025E2}"/>
              </a:ext>
            </a:extLst>
          </p:cNvPr>
          <p:cNvSpPr txBox="1"/>
          <p:nvPr/>
        </p:nvSpPr>
        <p:spPr>
          <a:xfrm>
            <a:off x="102656" y="4977247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오른쪽 대괄호 33">
            <a:extLst>
              <a:ext uri="{FF2B5EF4-FFF2-40B4-BE49-F238E27FC236}">
                <a16:creationId xmlns:a16="http://schemas.microsoft.com/office/drawing/2014/main" id="{CC1C977F-E592-430E-BB4C-2B9DF4CA503A}"/>
              </a:ext>
            </a:extLst>
          </p:cNvPr>
          <p:cNvSpPr/>
          <p:nvPr/>
        </p:nvSpPr>
        <p:spPr>
          <a:xfrm flipH="1">
            <a:off x="543633" y="6096426"/>
            <a:ext cx="54000" cy="820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491B11C-AD2B-4E0E-A668-2355B74F86D3}"/>
              </a:ext>
            </a:extLst>
          </p:cNvPr>
          <p:cNvSpPr txBox="1"/>
          <p:nvPr/>
        </p:nvSpPr>
        <p:spPr>
          <a:xfrm>
            <a:off x="142259" y="6408722"/>
            <a:ext cx="4475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6" name="오른쪽 대괄호 35">
            <a:extLst>
              <a:ext uri="{FF2B5EF4-FFF2-40B4-BE49-F238E27FC236}">
                <a16:creationId xmlns:a16="http://schemas.microsoft.com/office/drawing/2014/main" id="{89C6765F-7510-4B6C-9F05-4E5BF7BFFC07}"/>
              </a:ext>
            </a:extLst>
          </p:cNvPr>
          <p:cNvSpPr/>
          <p:nvPr/>
        </p:nvSpPr>
        <p:spPr>
          <a:xfrm flipH="1">
            <a:off x="543633" y="6946544"/>
            <a:ext cx="54000" cy="396568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092E526-FE4C-42EA-BDCA-4F25E4EE1F12}"/>
              </a:ext>
            </a:extLst>
          </p:cNvPr>
          <p:cNvSpPr txBox="1"/>
          <p:nvPr/>
        </p:nvSpPr>
        <p:spPr>
          <a:xfrm>
            <a:off x="102656" y="7046724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8" name="오른쪽 대괄호 37">
            <a:extLst>
              <a:ext uri="{FF2B5EF4-FFF2-40B4-BE49-F238E27FC236}">
                <a16:creationId xmlns:a16="http://schemas.microsoft.com/office/drawing/2014/main" id="{2C6498A3-8ED2-41D5-A9F2-BA58860ACD2E}"/>
              </a:ext>
            </a:extLst>
          </p:cNvPr>
          <p:cNvSpPr/>
          <p:nvPr/>
        </p:nvSpPr>
        <p:spPr>
          <a:xfrm flipH="1">
            <a:off x="543633" y="8111584"/>
            <a:ext cx="54000" cy="298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39D6E2-7787-4A58-AC18-FF4E65A82D45}"/>
              </a:ext>
            </a:extLst>
          </p:cNvPr>
          <p:cNvSpPr txBox="1"/>
          <p:nvPr/>
        </p:nvSpPr>
        <p:spPr>
          <a:xfrm>
            <a:off x="56302" y="8162880"/>
            <a:ext cx="53352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V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0" name="오른쪽 대괄호 39">
            <a:extLst>
              <a:ext uri="{FF2B5EF4-FFF2-40B4-BE49-F238E27FC236}">
                <a16:creationId xmlns:a16="http://schemas.microsoft.com/office/drawing/2014/main" id="{28A07957-128C-4410-B7A2-CFB2B0C87F93}"/>
              </a:ext>
            </a:extLst>
          </p:cNvPr>
          <p:cNvSpPr/>
          <p:nvPr/>
        </p:nvSpPr>
        <p:spPr>
          <a:xfrm flipH="1">
            <a:off x="543633" y="7370430"/>
            <a:ext cx="54000" cy="7164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1EFF08B-AB3E-4301-9EE4-1A6D593025E2}"/>
              </a:ext>
            </a:extLst>
          </p:cNvPr>
          <p:cNvSpPr txBox="1"/>
          <p:nvPr/>
        </p:nvSpPr>
        <p:spPr>
          <a:xfrm>
            <a:off x="102656" y="7630526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18412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2961D4F0-6349-4E0F-8FCB-6714878CD20F}"/>
              </a:ext>
            </a:extLst>
          </p:cNvPr>
          <p:cNvSpPr txBox="1"/>
          <p:nvPr/>
        </p:nvSpPr>
        <p:spPr>
          <a:xfrm>
            <a:off x="222160" y="7612342"/>
            <a:ext cx="64136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just"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ltiple alignment of OsCHIs with other CHIs. Amino acid sequences were aligned using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. Identical and similar amino acid residues are shaded in black and grey, respectively. Blue circles over the residues indicate the conserved residues forming the substrate-binding cleft in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d triangles indicate the residues participating in the hydrogen bond networks with substrates and catalytic water molecules.</a:t>
            </a: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/>
          <a:srcRect b="31631"/>
          <a:stretch/>
        </p:blipFill>
        <p:spPr>
          <a:xfrm>
            <a:off x="610785" y="855871"/>
            <a:ext cx="6058303" cy="53772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961D4F0-6349-4E0F-8FCB-6714878CD20F}"/>
              </a:ext>
            </a:extLst>
          </p:cNvPr>
          <p:cNvSpPr txBox="1"/>
          <p:nvPr/>
        </p:nvSpPr>
        <p:spPr>
          <a:xfrm>
            <a:off x="296482" y="314370"/>
            <a:ext cx="64136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continued from the previous page)</a:t>
            </a:r>
            <a:endParaRPr kumimoji="0" lang="ko-KR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6" name="타원 5"/>
          <p:cNvSpPr/>
          <p:nvPr/>
        </p:nvSpPr>
        <p:spPr>
          <a:xfrm>
            <a:off x="1895945" y="3758474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7" name="타원 6"/>
          <p:cNvSpPr/>
          <p:nvPr/>
        </p:nvSpPr>
        <p:spPr>
          <a:xfrm>
            <a:off x="1953130" y="3758474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8" name="이등변 삼각형 7"/>
          <p:cNvSpPr/>
          <p:nvPr/>
        </p:nvSpPr>
        <p:spPr>
          <a:xfrm>
            <a:off x="2056426" y="1098052"/>
            <a:ext cx="43200" cy="432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9" name="타원 8"/>
          <p:cNvSpPr/>
          <p:nvPr/>
        </p:nvSpPr>
        <p:spPr>
          <a:xfrm>
            <a:off x="2592842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1" name="타원 10"/>
          <p:cNvSpPr/>
          <p:nvPr/>
        </p:nvSpPr>
        <p:spPr>
          <a:xfrm>
            <a:off x="2746830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2" name="타원 11"/>
          <p:cNvSpPr/>
          <p:nvPr/>
        </p:nvSpPr>
        <p:spPr>
          <a:xfrm>
            <a:off x="2807155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3" name="타원 12"/>
          <p:cNvSpPr/>
          <p:nvPr/>
        </p:nvSpPr>
        <p:spPr>
          <a:xfrm>
            <a:off x="2964318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4" name="타원 13"/>
          <p:cNvSpPr/>
          <p:nvPr/>
        </p:nvSpPr>
        <p:spPr>
          <a:xfrm>
            <a:off x="2320567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5" name="타원 14"/>
          <p:cNvSpPr/>
          <p:nvPr/>
        </p:nvSpPr>
        <p:spPr>
          <a:xfrm>
            <a:off x="1947526" y="1098052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6" name="타원 15"/>
          <p:cNvSpPr/>
          <p:nvPr/>
        </p:nvSpPr>
        <p:spPr>
          <a:xfrm>
            <a:off x="2325350" y="3758474"/>
            <a:ext cx="43200" cy="43200"/>
          </a:xfrm>
          <a:prstGeom prst="ellipse">
            <a:avLst/>
          </a:prstGeom>
          <a:solidFill>
            <a:srgbClr val="0000CC"/>
          </a:solidFill>
          <a:ln w="6350">
            <a:solidFill>
              <a:srgbClr val="0000CC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7" name="이등변 삼각형 16"/>
          <p:cNvSpPr/>
          <p:nvPr/>
        </p:nvSpPr>
        <p:spPr>
          <a:xfrm>
            <a:off x="2591399" y="1029782"/>
            <a:ext cx="43200" cy="432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8" name="이등변 삼각형 17"/>
          <p:cNvSpPr/>
          <p:nvPr/>
        </p:nvSpPr>
        <p:spPr>
          <a:xfrm>
            <a:off x="1895562" y="3688181"/>
            <a:ext cx="43200" cy="432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9" name="이등변 삼각형 18"/>
          <p:cNvSpPr/>
          <p:nvPr/>
        </p:nvSpPr>
        <p:spPr>
          <a:xfrm>
            <a:off x="5032975" y="1093289"/>
            <a:ext cx="43200" cy="43200"/>
          </a:xfrm>
          <a:prstGeom prst="triangle">
            <a:avLst/>
          </a:prstGeom>
          <a:solidFill>
            <a:srgbClr val="FF0000"/>
          </a:solidFill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1013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0" name="오른쪽 대괄호 19">
            <a:extLst>
              <a:ext uri="{FF2B5EF4-FFF2-40B4-BE49-F238E27FC236}">
                <a16:creationId xmlns:a16="http://schemas.microsoft.com/office/drawing/2014/main" id="{CC1C977F-E592-430E-BB4C-2B9DF4CA503A}"/>
              </a:ext>
            </a:extLst>
          </p:cNvPr>
          <p:cNvSpPr/>
          <p:nvPr/>
        </p:nvSpPr>
        <p:spPr>
          <a:xfrm flipH="1">
            <a:off x="543633" y="1199443"/>
            <a:ext cx="54000" cy="820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91B11C-AD2B-4E0E-A668-2355B74F86D3}"/>
              </a:ext>
            </a:extLst>
          </p:cNvPr>
          <p:cNvSpPr txBox="1"/>
          <p:nvPr/>
        </p:nvSpPr>
        <p:spPr>
          <a:xfrm>
            <a:off x="142259" y="1511739"/>
            <a:ext cx="4475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2" name="오른쪽 대괄호 21">
            <a:extLst>
              <a:ext uri="{FF2B5EF4-FFF2-40B4-BE49-F238E27FC236}">
                <a16:creationId xmlns:a16="http://schemas.microsoft.com/office/drawing/2014/main" id="{89C6765F-7510-4B6C-9F05-4E5BF7BFFC07}"/>
              </a:ext>
            </a:extLst>
          </p:cNvPr>
          <p:cNvSpPr/>
          <p:nvPr/>
        </p:nvSpPr>
        <p:spPr>
          <a:xfrm flipH="1">
            <a:off x="543633" y="2049561"/>
            <a:ext cx="54000" cy="396568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092E526-FE4C-42EA-BDCA-4F25E4EE1F12}"/>
              </a:ext>
            </a:extLst>
          </p:cNvPr>
          <p:cNvSpPr txBox="1"/>
          <p:nvPr/>
        </p:nvSpPr>
        <p:spPr>
          <a:xfrm>
            <a:off x="102656" y="2149741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4" name="오른쪽 대괄호 23">
            <a:extLst>
              <a:ext uri="{FF2B5EF4-FFF2-40B4-BE49-F238E27FC236}">
                <a16:creationId xmlns:a16="http://schemas.microsoft.com/office/drawing/2014/main" id="{2C6498A3-8ED2-41D5-A9F2-BA58860ACD2E}"/>
              </a:ext>
            </a:extLst>
          </p:cNvPr>
          <p:cNvSpPr/>
          <p:nvPr/>
        </p:nvSpPr>
        <p:spPr>
          <a:xfrm flipH="1">
            <a:off x="543633" y="3214601"/>
            <a:ext cx="54000" cy="298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F39D6E2-7787-4A58-AC18-FF4E65A82D45}"/>
              </a:ext>
            </a:extLst>
          </p:cNvPr>
          <p:cNvSpPr txBox="1"/>
          <p:nvPr/>
        </p:nvSpPr>
        <p:spPr>
          <a:xfrm>
            <a:off x="56302" y="3265897"/>
            <a:ext cx="53352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V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6" name="오른쪽 대괄호 25">
            <a:extLst>
              <a:ext uri="{FF2B5EF4-FFF2-40B4-BE49-F238E27FC236}">
                <a16:creationId xmlns:a16="http://schemas.microsoft.com/office/drawing/2014/main" id="{28A07957-128C-4410-B7A2-CFB2B0C87F93}"/>
              </a:ext>
            </a:extLst>
          </p:cNvPr>
          <p:cNvSpPr/>
          <p:nvPr/>
        </p:nvSpPr>
        <p:spPr>
          <a:xfrm flipH="1">
            <a:off x="543633" y="2473447"/>
            <a:ext cx="54000" cy="7164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1EFF08B-AB3E-4301-9EE4-1A6D593025E2}"/>
              </a:ext>
            </a:extLst>
          </p:cNvPr>
          <p:cNvSpPr txBox="1"/>
          <p:nvPr/>
        </p:nvSpPr>
        <p:spPr>
          <a:xfrm>
            <a:off x="102656" y="2733543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28" name="오른쪽 대괄호 27">
            <a:extLst>
              <a:ext uri="{FF2B5EF4-FFF2-40B4-BE49-F238E27FC236}">
                <a16:creationId xmlns:a16="http://schemas.microsoft.com/office/drawing/2014/main" id="{CC1C977F-E592-430E-BB4C-2B9DF4CA503A}"/>
              </a:ext>
            </a:extLst>
          </p:cNvPr>
          <p:cNvSpPr/>
          <p:nvPr/>
        </p:nvSpPr>
        <p:spPr>
          <a:xfrm flipH="1">
            <a:off x="543633" y="3852722"/>
            <a:ext cx="54000" cy="820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Palatino Linotype" panose="02040502050505030304" pitchFamily="18" charset="0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491B11C-AD2B-4E0E-A668-2355B74F86D3}"/>
              </a:ext>
            </a:extLst>
          </p:cNvPr>
          <p:cNvSpPr txBox="1"/>
          <p:nvPr/>
        </p:nvSpPr>
        <p:spPr>
          <a:xfrm>
            <a:off x="142259" y="4165018"/>
            <a:ext cx="447566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0" name="오른쪽 대괄호 29">
            <a:extLst>
              <a:ext uri="{FF2B5EF4-FFF2-40B4-BE49-F238E27FC236}">
                <a16:creationId xmlns:a16="http://schemas.microsoft.com/office/drawing/2014/main" id="{89C6765F-7510-4B6C-9F05-4E5BF7BFFC07}"/>
              </a:ext>
            </a:extLst>
          </p:cNvPr>
          <p:cNvSpPr/>
          <p:nvPr/>
        </p:nvSpPr>
        <p:spPr>
          <a:xfrm flipH="1">
            <a:off x="543633" y="4702840"/>
            <a:ext cx="54000" cy="396568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092E526-FE4C-42EA-BDCA-4F25E4EE1F12}"/>
              </a:ext>
            </a:extLst>
          </p:cNvPr>
          <p:cNvSpPr txBox="1"/>
          <p:nvPr/>
        </p:nvSpPr>
        <p:spPr>
          <a:xfrm>
            <a:off x="102656" y="4803020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2" name="오른쪽 대괄호 31">
            <a:extLst>
              <a:ext uri="{FF2B5EF4-FFF2-40B4-BE49-F238E27FC236}">
                <a16:creationId xmlns:a16="http://schemas.microsoft.com/office/drawing/2014/main" id="{2C6498A3-8ED2-41D5-A9F2-BA58860ACD2E}"/>
              </a:ext>
            </a:extLst>
          </p:cNvPr>
          <p:cNvSpPr/>
          <p:nvPr/>
        </p:nvSpPr>
        <p:spPr>
          <a:xfrm flipH="1">
            <a:off x="543633" y="5867880"/>
            <a:ext cx="54000" cy="2988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F39D6E2-7787-4A58-AC18-FF4E65A82D45}"/>
              </a:ext>
            </a:extLst>
          </p:cNvPr>
          <p:cNvSpPr txBox="1"/>
          <p:nvPr/>
        </p:nvSpPr>
        <p:spPr>
          <a:xfrm>
            <a:off x="56302" y="5919176"/>
            <a:ext cx="53352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V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4" name="오른쪽 대괄호 33">
            <a:extLst>
              <a:ext uri="{FF2B5EF4-FFF2-40B4-BE49-F238E27FC236}">
                <a16:creationId xmlns:a16="http://schemas.microsoft.com/office/drawing/2014/main" id="{28A07957-128C-4410-B7A2-CFB2B0C87F93}"/>
              </a:ext>
            </a:extLst>
          </p:cNvPr>
          <p:cNvSpPr/>
          <p:nvPr/>
        </p:nvSpPr>
        <p:spPr>
          <a:xfrm flipH="1">
            <a:off x="543633" y="5126726"/>
            <a:ext cx="54000" cy="716400"/>
          </a:xfrm>
          <a:prstGeom prst="rightBracket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675" b="1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1EFF08B-AB3E-4301-9EE4-1A6D593025E2}"/>
              </a:ext>
            </a:extLst>
          </p:cNvPr>
          <p:cNvSpPr txBox="1"/>
          <p:nvPr/>
        </p:nvSpPr>
        <p:spPr>
          <a:xfrm>
            <a:off x="102656" y="5386822"/>
            <a:ext cx="48716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675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Type III</a:t>
            </a:r>
            <a:endParaRPr kumimoji="0" lang="ko-KR" altLang="en-US" sz="675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87205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TextBox 183"/>
          <p:cNvSpPr txBox="1"/>
          <p:nvPr/>
        </p:nvSpPr>
        <p:spPr>
          <a:xfrm>
            <a:off x="328392" y="7712361"/>
            <a:ext cx="624658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Purification of recombinant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CHS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ed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recombinant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sCHS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produced in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col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N-terminal His-tagged proteins. Recombinant OsCHI1 (A) was purified with Ni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ffinity chromatography followed by CM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haro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atography. OsCHI3 (B), OsCHI6 (C), and OsCHI7 (D) proteins were purified through Ni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ffinity chromatography. M; size marker, 1; crude extract, 2; protein fractions after Ni</a:t>
            </a:r>
            <a:r>
              <a:rPr lang="en-US" altLang="ko-KR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ffinity chromatography, 3; proteins after CM-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pharos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hromatography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그림 63">
            <a:extLst>
              <a:ext uri="{FF2B5EF4-FFF2-40B4-BE49-F238E27FC236}">
                <a16:creationId xmlns:a16="http://schemas.microsoft.com/office/drawing/2014/main" id="{BA5D9866-85D5-4BCB-981E-52F4EED094E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168" t="6068" r="12000" b="16398"/>
          <a:stretch/>
        </p:blipFill>
        <p:spPr>
          <a:xfrm>
            <a:off x="1891270" y="1321862"/>
            <a:ext cx="1337735" cy="2053237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E3263F43-F478-462D-99A4-0B1D1F9747F2}"/>
              </a:ext>
            </a:extLst>
          </p:cNvPr>
          <p:cNvSpPr txBox="1"/>
          <p:nvPr/>
        </p:nvSpPr>
        <p:spPr>
          <a:xfrm>
            <a:off x="1924249" y="1055636"/>
            <a:ext cx="13267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M    1  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2  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그림 66">
            <a:extLst>
              <a:ext uri="{FF2B5EF4-FFF2-40B4-BE49-F238E27FC236}">
                <a16:creationId xmlns:a16="http://schemas.microsoft.com/office/drawing/2014/main" id="{5123302B-C16E-4F12-8E6B-122E21354AA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398" t="3564" r="30806" b="13119"/>
          <a:stretch/>
        </p:blipFill>
        <p:spPr>
          <a:xfrm>
            <a:off x="4475089" y="1318703"/>
            <a:ext cx="1072626" cy="2075552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D08969D0-B022-4758-B42E-0E9165BD0C4D}"/>
              </a:ext>
            </a:extLst>
          </p:cNvPr>
          <p:cNvSpPr txBox="1"/>
          <p:nvPr/>
        </p:nvSpPr>
        <p:spPr>
          <a:xfrm>
            <a:off x="4498652" y="1055636"/>
            <a:ext cx="1105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M   </a:t>
            </a:r>
            <a:r>
              <a:rPr lang="en-US" altLang="ko-KR" sz="105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     2 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그림 69">
            <a:extLst>
              <a:ext uri="{FF2B5EF4-FFF2-40B4-BE49-F238E27FC236}">
                <a16:creationId xmlns:a16="http://schemas.microsoft.com/office/drawing/2014/main" id="{A84E6A8A-6E49-4A3E-94BA-B15EC6604396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06" t="7194" r="15544" b="14397"/>
          <a:stretch/>
        </p:blipFill>
        <p:spPr>
          <a:xfrm>
            <a:off x="1885065" y="3965621"/>
            <a:ext cx="1084295" cy="2112746"/>
          </a:xfrm>
          <a:prstGeom prst="rect">
            <a:avLst/>
          </a:prstGeom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2B579126-C293-46CC-8D55-21F6191C284B}"/>
              </a:ext>
            </a:extLst>
          </p:cNvPr>
          <p:cNvSpPr txBox="1"/>
          <p:nvPr/>
        </p:nvSpPr>
        <p:spPr>
          <a:xfrm>
            <a:off x="1922565" y="3702553"/>
            <a:ext cx="1105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M     1  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2 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그림 72">
            <a:extLst>
              <a:ext uri="{FF2B5EF4-FFF2-40B4-BE49-F238E27FC236}">
                <a16:creationId xmlns:a16="http://schemas.microsoft.com/office/drawing/2014/main" id="{BE66074B-68F2-43B5-A6BE-8DFB102B695F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184" t="3987" r="18496" b="16393"/>
          <a:stretch/>
        </p:blipFill>
        <p:spPr>
          <a:xfrm>
            <a:off x="4475089" y="3965621"/>
            <a:ext cx="1072626" cy="2109208"/>
          </a:xfrm>
          <a:prstGeom prst="rect">
            <a:avLst/>
          </a:prstGeom>
        </p:spPr>
      </p:pic>
      <p:sp>
        <p:nvSpPr>
          <p:cNvPr id="74" name="TextBox 73">
            <a:extLst>
              <a:ext uri="{FF2B5EF4-FFF2-40B4-BE49-F238E27FC236}">
                <a16:creationId xmlns:a16="http://schemas.microsoft.com/office/drawing/2014/main" id="{25816EEE-87F4-4E3F-9748-D91505DB7A4F}"/>
              </a:ext>
            </a:extLst>
          </p:cNvPr>
          <p:cNvSpPr txBox="1"/>
          <p:nvPr/>
        </p:nvSpPr>
        <p:spPr>
          <a:xfrm>
            <a:off x="4477988" y="3702553"/>
            <a:ext cx="11052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M  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1     2 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E6264C0-273B-45E4-A8BB-5563589752D0}"/>
              </a:ext>
            </a:extLst>
          </p:cNvPr>
          <p:cNvSpPr txBox="1"/>
          <p:nvPr/>
        </p:nvSpPr>
        <p:spPr>
          <a:xfrm>
            <a:off x="1041836" y="1031221"/>
            <a:ext cx="464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16528F88-30D4-4FF4-A4DF-2960779B393A}"/>
              </a:ext>
            </a:extLst>
          </p:cNvPr>
          <p:cNvSpPr txBox="1"/>
          <p:nvPr/>
        </p:nvSpPr>
        <p:spPr>
          <a:xfrm>
            <a:off x="3626389" y="1031220"/>
            <a:ext cx="4467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E69224E6-9455-4F65-A251-B502C108E75C}"/>
              </a:ext>
            </a:extLst>
          </p:cNvPr>
          <p:cNvSpPr txBox="1"/>
          <p:nvPr/>
        </p:nvSpPr>
        <p:spPr>
          <a:xfrm>
            <a:off x="1041835" y="3660724"/>
            <a:ext cx="502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C164B78-1891-4000-9D85-45591AB53B9D}"/>
              </a:ext>
            </a:extLst>
          </p:cNvPr>
          <p:cNvSpPr txBox="1"/>
          <p:nvPr/>
        </p:nvSpPr>
        <p:spPr>
          <a:xfrm>
            <a:off x="3621439" y="3664479"/>
            <a:ext cx="426156" cy="307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직선 연결선 114"/>
          <p:cNvCxnSpPr/>
          <p:nvPr/>
        </p:nvCxnSpPr>
        <p:spPr>
          <a:xfrm>
            <a:off x="1812034" y="166394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직선 연결선 115"/>
          <p:cNvCxnSpPr/>
          <p:nvPr/>
        </p:nvCxnSpPr>
        <p:spPr>
          <a:xfrm>
            <a:off x="1812034" y="177134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직선 연결선 116"/>
          <p:cNvCxnSpPr/>
          <p:nvPr/>
        </p:nvCxnSpPr>
        <p:spPr>
          <a:xfrm>
            <a:off x="1812034" y="187191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직선 연결선 117"/>
          <p:cNvCxnSpPr/>
          <p:nvPr/>
        </p:nvCxnSpPr>
        <p:spPr>
          <a:xfrm>
            <a:off x="1812034" y="208675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연결선 118"/>
          <p:cNvCxnSpPr/>
          <p:nvPr/>
        </p:nvCxnSpPr>
        <p:spPr>
          <a:xfrm>
            <a:off x="1812034" y="229032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2"/>
          <p:cNvSpPr txBox="1">
            <a:spLocks noChangeArrowheads="1"/>
          </p:cNvSpPr>
          <p:nvPr/>
        </p:nvSpPr>
        <p:spPr bwMode="auto">
          <a:xfrm>
            <a:off x="1443587" y="1139500"/>
            <a:ext cx="36892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1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Da</a:t>
            </a:r>
            <a:endParaRPr lang="ko-KR" altLang="en-US" sz="11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1" name="TextBox 12"/>
          <p:cNvSpPr txBox="1">
            <a:spLocks noChangeArrowheads="1"/>
          </p:cNvSpPr>
          <p:nvPr/>
        </p:nvSpPr>
        <p:spPr bwMode="auto">
          <a:xfrm>
            <a:off x="1497496" y="1540836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" name="TextBox 12"/>
          <p:cNvSpPr txBox="1">
            <a:spLocks noChangeArrowheads="1"/>
          </p:cNvSpPr>
          <p:nvPr/>
        </p:nvSpPr>
        <p:spPr bwMode="auto">
          <a:xfrm>
            <a:off x="1497496" y="1648239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7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" name="TextBox 12"/>
          <p:cNvSpPr txBox="1">
            <a:spLocks noChangeArrowheads="1"/>
          </p:cNvSpPr>
          <p:nvPr/>
        </p:nvSpPr>
        <p:spPr bwMode="auto">
          <a:xfrm>
            <a:off x="1497496" y="1748801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5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85" name="TextBox 12"/>
          <p:cNvSpPr txBox="1">
            <a:spLocks noChangeArrowheads="1"/>
          </p:cNvSpPr>
          <p:nvPr/>
        </p:nvSpPr>
        <p:spPr bwMode="auto">
          <a:xfrm>
            <a:off x="1497496" y="1963648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86" name="TextBox 12"/>
          <p:cNvSpPr txBox="1">
            <a:spLocks noChangeArrowheads="1"/>
          </p:cNvSpPr>
          <p:nvPr/>
        </p:nvSpPr>
        <p:spPr bwMode="auto">
          <a:xfrm>
            <a:off x="1497496" y="2167219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187" name="직선 연결선 186"/>
          <p:cNvCxnSpPr/>
          <p:nvPr/>
        </p:nvCxnSpPr>
        <p:spPr>
          <a:xfrm>
            <a:off x="1812034" y="264998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8" name="TextBox 12"/>
          <p:cNvSpPr txBox="1">
            <a:spLocks noChangeArrowheads="1"/>
          </p:cNvSpPr>
          <p:nvPr/>
        </p:nvSpPr>
        <p:spPr bwMode="auto">
          <a:xfrm>
            <a:off x="1497496" y="2526878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189" name="직선 연결선 188"/>
          <p:cNvCxnSpPr/>
          <p:nvPr/>
        </p:nvCxnSpPr>
        <p:spPr>
          <a:xfrm>
            <a:off x="1812034" y="155474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2"/>
          <p:cNvSpPr txBox="1">
            <a:spLocks noChangeArrowheads="1"/>
          </p:cNvSpPr>
          <p:nvPr/>
        </p:nvSpPr>
        <p:spPr bwMode="auto">
          <a:xfrm>
            <a:off x="1497496" y="1431631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3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191" name="직선 연결선 190"/>
          <p:cNvCxnSpPr/>
          <p:nvPr/>
        </p:nvCxnSpPr>
        <p:spPr>
          <a:xfrm>
            <a:off x="1812034" y="143215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TextBox 12"/>
          <p:cNvSpPr txBox="1">
            <a:spLocks noChangeArrowheads="1"/>
          </p:cNvSpPr>
          <p:nvPr/>
        </p:nvSpPr>
        <p:spPr bwMode="auto">
          <a:xfrm>
            <a:off x="1497496" y="1309042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193" name="직선 연결선 192"/>
          <p:cNvCxnSpPr/>
          <p:nvPr/>
        </p:nvCxnSpPr>
        <p:spPr>
          <a:xfrm>
            <a:off x="4391616" y="168357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직선 연결선 193"/>
          <p:cNvCxnSpPr/>
          <p:nvPr/>
        </p:nvCxnSpPr>
        <p:spPr>
          <a:xfrm>
            <a:off x="4391616" y="179097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직선 연결선 194"/>
          <p:cNvCxnSpPr/>
          <p:nvPr/>
        </p:nvCxnSpPr>
        <p:spPr>
          <a:xfrm>
            <a:off x="4391616" y="189153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연결선 195"/>
          <p:cNvCxnSpPr/>
          <p:nvPr/>
        </p:nvCxnSpPr>
        <p:spPr>
          <a:xfrm>
            <a:off x="4391616" y="207538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직선 연결선 196"/>
          <p:cNvCxnSpPr/>
          <p:nvPr/>
        </p:nvCxnSpPr>
        <p:spPr>
          <a:xfrm>
            <a:off x="4391616" y="2278957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2"/>
          <p:cNvSpPr txBox="1">
            <a:spLocks noChangeArrowheads="1"/>
          </p:cNvSpPr>
          <p:nvPr/>
        </p:nvSpPr>
        <p:spPr bwMode="auto">
          <a:xfrm>
            <a:off x="4023169" y="1169456"/>
            <a:ext cx="36892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1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Da</a:t>
            </a:r>
            <a:endParaRPr lang="ko-KR" altLang="en-US" sz="11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99" name="TextBox 12"/>
          <p:cNvSpPr txBox="1">
            <a:spLocks noChangeArrowheads="1"/>
          </p:cNvSpPr>
          <p:nvPr/>
        </p:nvSpPr>
        <p:spPr bwMode="auto">
          <a:xfrm>
            <a:off x="4077078" y="1560460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00" name="TextBox 12"/>
          <p:cNvSpPr txBox="1">
            <a:spLocks noChangeArrowheads="1"/>
          </p:cNvSpPr>
          <p:nvPr/>
        </p:nvSpPr>
        <p:spPr bwMode="auto">
          <a:xfrm>
            <a:off x="4077078" y="1667863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7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01" name="TextBox 12"/>
          <p:cNvSpPr txBox="1">
            <a:spLocks noChangeArrowheads="1"/>
          </p:cNvSpPr>
          <p:nvPr/>
        </p:nvSpPr>
        <p:spPr bwMode="auto">
          <a:xfrm>
            <a:off x="4077078" y="1768425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5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02" name="TextBox 12"/>
          <p:cNvSpPr txBox="1">
            <a:spLocks noChangeArrowheads="1"/>
          </p:cNvSpPr>
          <p:nvPr/>
        </p:nvSpPr>
        <p:spPr bwMode="auto">
          <a:xfrm>
            <a:off x="4077078" y="1952276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03" name="TextBox 12"/>
          <p:cNvSpPr txBox="1">
            <a:spLocks noChangeArrowheads="1"/>
          </p:cNvSpPr>
          <p:nvPr/>
        </p:nvSpPr>
        <p:spPr bwMode="auto">
          <a:xfrm>
            <a:off x="4077078" y="2155847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04" name="직선 연결선 203"/>
          <p:cNvCxnSpPr/>
          <p:nvPr/>
        </p:nvCxnSpPr>
        <p:spPr>
          <a:xfrm>
            <a:off x="4391616" y="264894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TextBox 12"/>
          <p:cNvSpPr txBox="1">
            <a:spLocks noChangeArrowheads="1"/>
          </p:cNvSpPr>
          <p:nvPr/>
        </p:nvSpPr>
        <p:spPr bwMode="auto">
          <a:xfrm>
            <a:off x="4077078" y="2525838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06" name="직선 연결선 205"/>
          <p:cNvCxnSpPr/>
          <p:nvPr/>
        </p:nvCxnSpPr>
        <p:spPr>
          <a:xfrm>
            <a:off x="4391616" y="157436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TextBox 12"/>
          <p:cNvSpPr txBox="1">
            <a:spLocks noChangeArrowheads="1"/>
          </p:cNvSpPr>
          <p:nvPr/>
        </p:nvSpPr>
        <p:spPr bwMode="auto">
          <a:xfrm>
            <a:off x="4077078" y="1461587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3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08" name="직선 연결선 207"/>
          <p:cNvCxnSpPr/>
          <p:nvPr/>
        </p:nvCxnSpPr>
        <p:spPr>
          <a:xfrm>
            <a:off x="4391616" y="146210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9" name="TextBox 12"/>
          <p:cNvSpPr txBox="1">
            <a:spLocks noChangeArrowheads="1"/>
          </p:cNvSpPr>
          <p:nvPr/>
        </p:nvSpPr>
        <p:spPr bwMode="auto">
          <a:xfrm>
            <a:off x="4077078" y="1338998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10" name="직선 연결선 209"/>
          <p:cNvCxnSpPr/>
          <p:nvPr/>
        </p:nvCxnSpPr>
        <p:spPr>
          <a:xfrm>
            <a:off x="1809394" y="435117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직선 연결선 210"/>
          <p:cNvCxnSpPr/>
          <p:nvPr/>
        </p:nvCxnSpPr>
        <p:spPr>
          <a:xfrm>
            <a:off x="1809394" y="445858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직선 연결선 211"/>
          <p:cNvCxnSpPr/>
          <p:nvPr/>
        </p:nvCxnSpPr>
        <p:spPr>
          <a:xfrm>
            <a:off x="1809394" y="455914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직선 연결선 212"/>
          <p:cNvCxnSpPr/>
          <p:nvPr/>
        </p:nvCxnSpPr>
        <p:spPr>
          <a:xfrm>
            <a:off x="1809394" y="475849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직선 연결선 213"/>
          <p:cNvCxnSpPr/>
          <p:nvPr/>
        </p:nvCxnSpPr>
        <p:spPr>
          <a:xfrm>
            <a:off x="1809394" y="496206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TextBox 12"/>
          <p:cNvSpPr txBox="1">
            <a:spLocks noChangeArrowheads="1"/>
          </p:cNvSpPr>
          <p:nvPr/>
        </p:nvSpPr>
        <p:spPr bwMode="auto">
          <a:xfrm>
            <a:off x="1440947" y="3806069"/>
            <a:ext cx="36892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1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Da</a:t>
            </a:r>
            <a:endParaRPr lang="ko-KR" altLang="en-US" sz="11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16" name="TextBox 12"/>
          <p:cNvSpPr txBox="1">
            <a:spLocks noChangeArrowheads="1"/>
          </p:cNvSpPr>
          <p:nvPr/>
        </p:nvSpPr>
        <p:spPr bwMode="auto">
          <a:xfrm>
            <a:off x="1494856" y="4222903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17" name="TextBox 12"/>
          <p:cNvSpPr txBox="1">
            <a:spLocks noChangeArrowheads="1"/>
          </p:cNvSpPr>
          <p:nvPr/>
        </p:nvSpPr>
        <p:spPr bwMode="auto">
          <a:xfrm>
            <a:off x="1494856" y="4335472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7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18" name="TextBox 12"/>
          <p:cNvSpPr txBox="1">
            <a:spLocks noChangeArrowheads="1"/>
          </p:cNvSpPr>
          <p:nvPr/>
        </p:nvSpPr>
        <p:spPr bwMode="auto">
          <a:xfrm>
            <a:off x="1494856" y="4436034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5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19" name="TextBox 12"/>
          <p:cNvSpPr txBox="1">
            <a:spLocks noChangeArrowheads="1"/>
          </p:cNvSpPr>
          <p:nvPr/>
        </p:nvSpPr>
        <p:spPr bwMode="auto">
          <a:xfrm>
            <a:off x="1494856" y="4635383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20" name="TextBox 12"/>
          <p:cNvSpPr txBox="1">
            <a:spLocks noChangeArrowheads="1"/>
          </p:cNvSpPr>
          <p:nvPr/>
        </p:nvSpPr>
        <p:spPr bwMode="auto">
          <a:xfrm>
            <a:off x="1494856" y="4838954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21" name="직선 연결선 220"/>
          <p:cNvCxnSpPr/>
          <p:nvPr/>
        </p:nvCxnSpPr>
        <p:spPr>
          <a:xfrm>
            <a:off x="1809394" y="5342387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2" name="TextBox 12"/>
          <p:cNvSpPr txBox="1">
            <a:spLocks noChangeArrowheads="1"/>
          </p:cNvSpPr>
          <p:nvPr/>
        </p:nvSpPr>
        <p:spPr bwMode="auto">
          <a:xfrm>
            <a:off x="1494856" y="5219277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23" name="직선 연결선 222"/>
          <p:cNvCxnSpPr/>
          <p:nvPr/>
        </p:nvCxnSpPr>
        <p:spPr>
          <a:xfrm>
            <a:off x="1809394" y="423680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4" name="TextBox 12"/>
          <p:cNvSpPr txBox="1">
            <a:spLocks noChangeArrowheads="1"/>
          </p:cNvSpPr>
          <p:nvPr/>
        </p:nvSpPr>
        <p:spPr bwMode="auto">
          <a:xfrm>
            <a:off x="1494856" y="4113698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3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25" name="직선 연결선 224"/>
          <p:cNvCxnSpPr/>
          <p:nvPr/>
        </p:nvCxnSpPr>
        <p:spPr>
          <a:xfrm>
            <a:off x="1809394" y="409872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6" name="TextBox 12"/>
          <p:cNvSpPr txBox="1">
            <a:spLocks noChangeArrowheads="1"/>
          </p:cNvSpPr>
          <p:nvPr/>
        </p:nvSpPr>
        <p:spPr bwMode="auto">
          <a:xfrm>
            <a:off x="1494856" y="3975611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27" name="직선 연결선 226"/>
          <p:cNvCxnSpPr/>
          <p:nvPr/>
        </p:nvCxnSpPr>
        <p:spPr>
          <a:xfrm>
            <a:off x="4387715" y="438154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직선 연결선 227"/>
          <p:cNvCxnSpPr/>
          <p:nvPr/>
        </p:nvCxnSpPr>
        <p:spPr>
          <a:xfrm>
            <a:off x="4387715" y="448894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직선 연결선 228"/>
          <p:cNvCxnSpPr/>
          <p:nvPr/>
        </p:nvCxnSpPr>
        <p:spPr>
          <a:xfrm>
            <a:off x="4387715" y="458950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직선 연결선 229"/>
          <p:cNvCxnSpPr/>
          <p:nvPr/>
        </p:nvCxnSpPr>
        <p:spPr>
          <a:xfrm>
            <a:off x="4387715" y="479918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직선 연결선 230"/>
          <p:cNvCxnSpPr/>
          <p:nvPr/>
        </p:nvCxnSpPr>
        <p:spPr>
          <a:xfrm>
            <a:off x="4387715" y="5007923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TextBox 12"/>
          <p:cNvSpPr txBox="1">
            <a:spLocks noChangeArrowheads="1"/>
          </p:cNvSpPr>
          <p:nvPr/>
        </p:nvSpPr>
        <p:spPr bwMode="auto">
          <a:xfrm>
            <a:off x="4019268" y="3846762"/>
            <a:ext cx="36892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100" dirty="0" err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kDa</a:t>
            </a:r>
            <a:endParaRPr lang="ko-KR" altLang="en-US" sz="11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33" name="TextBox 12"/>
          <p:cNvSpPr txBox="1">
            <a:spLocks noChangeArrowheads="1"/>
          </p:cNvSpPr>
          <p:nvPr/>
        </p:nvSpPr>
        <p:spPr bwMode="auto">
          <a:xfrm>
            <a:off x="4073177" y="4258430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0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34" name="TextBox 12"/>
          <p:cNvSpPr txBox="1">
            <a:spLocks noChangeArrowheads="1"/>
          </p:cNvSpPr>
          <p:nvPr/>
        </p:nvSpPr>
        <p:spPr bwMode="auto">
          <a:xfrm>
            <a:off x="4073177" y="4365833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7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35" name="TextBox 12"/>
          <p:cNvSpPr txBox="1">
            <a:spLocks noChangeArrowheads="1"/>
          </p:cNvSpPr>
          <p:nvPr/>
        </p:nvSpPr>
        <p:spPr bwMode="auto">
          <a:xfrm>
            <a:off x="4073177" y="4466395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5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36" name="TextBox 12"/>
          <p:cNvSpPr txBox="1">
            <a:spLocks noChangeArrowheads="1"/>
          </p:cNvSpPr>
          <p:nvPr/>
        </p:nvSpPr>
        <p:spPr bwMode="auto">
          <a:xfrm>
            <a:off x="4073177" y="4676076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237" name="TextBox 12"/>
          <p:cNvSpPr txBox="1">
            <a:spLocks noChangeArrowheads="1"/>
          </p:cNvSpPr>
          <p:nvPr/>
        </p:nvSpPr>
        <p:spPr bwMode="auto">
          <a:xfrm>
            <a:off x="4073177" y="4884813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38" name="직선 연결선 237"/>
          <p:cNvCxnSpPr/>
          <p:nvPr/>
        </p:nvCxnSpPr>
        <p:spPr>
          <a:xfrm>
            <a:off x="4387715" y="539341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TextBox 12"/>
          <p:cNvSpPr txBox="1">
            <a:spLocks noChangeArrowheads="1"/>
          </p:cNvSpPr>
          <p:nvPr/>
        </p:nvSpPr>
        <p:spPr bwMode="auto">
          <a:xfrm>
            <a:off x="4073177" y="5270302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5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40" name="직선 연결선 239"/>
          <p:cNvCxnSpPr/>
          <p:nvPr/>
        </p:nvCxnSpPr>
        <p:spPr>
          <a:xfrm>
            <a:off x="4387715" y="427233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12"/>
          <p:cNvSpPr txBox="1">
            <a:spLocks noChangeArrowheads="1"/>
          </p:cNvSpPr>
          <p:nvPr/>
        </p:nvSpPr>
        <p:spPr bwMode="auto">
          <a:xfrm>
            <a:off x="4073177" y="4144059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3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cxnSp>
        <p:nvCxnSpPr>
          <p:cNvPr id="242" name="직선 연결선 241"/>
          <p:cNvCxnSpPr/>
          <p:nvPr/>
        </p:nvCxnSpPr>
        <p:spPr>
          <a:xfrm>
            <a:off x="4387715" y="414458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TextBox 12"/>
          <p:cNvSpPr txBox="1">
            <a:spLocks noChangeArrowheads="1"/>
          </p:cNvSpPr>
          <p:nvPr/>
        </p:nvSpPr>
        <p:spPr bwMode="auto">
          <a:xfrm>
            <a:off x="4073177" y="4021470"/>
            <a:ext cx="31501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36000" rIns="36000">
            <a:spAutoFit/>
          </a:bodyPr>
          <a:lstStyle>
            <a:lvl1pPr latinLnBrk="1">
              <a:spcBef>
                <a:spcPct val="20000"/>
              </a:spcBef>
              <a:buClr>
                <a:schemeClr val="accent1"/>
              </a:buClr>
              <a:buSzPct val="70000"/>
              <a:buFont typeface="Wingdings 2" panose="05020102010507070707" pitchFamily="18" charset="2"/>
              <a:buChar char="¢"/>
              <a:defRPr sz="32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1pPr>
            <a:lvl2pPr marL="742950" indent="-285750" latinLnBrk="1">
              <a:spcBef>
                <a:spcPct val="20000"/>
              </a:spcBef>
              <a:buClr>
                <a:schemeClr val="tx2"/>
              </a:buClr>
              <a:buSzPct val="70000"/>
              <a:buFont typeface="Wingdings" panose="05000000000000000000" pitchFamily="2" charset="2"/>
              <a:buChar char="p"/>
              <a:defRPr sz="28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2pPr>
            <a:lvl3pPr marL="1143000" indent="-228600" latinLnBrk="1">
              <a:spcBef>
                <a:spcPct val="20000"/>
              </a:spcBef>
              <a:buClr>
                <a:srgbClr val="B5AD67"/>
              </a:buClr>
              <a:buSzPct val="140000"/>
              <a:buFont typeface="Wingdings" panose="05000000000000000000" pitchFamily="2" charset="2"/>
              <a:buChar char="§"/>
              <a:defRPr sz="24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3pPr>
            <a:lvl4pPr marL="1600200" indent="-228600" latinLnBrk="1">
              <a:spcBef>
                <a:spcPct val="20000"/>
              </a:spcBef>
              <a:buClr>
                <a:srgbClr val="61A9B8"/>
              </a:buClr>
              <a:buSzPct val="12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4pPr>
            <a:lvl5pPr marL="2057400" indent="-228600" latinLnBrk="1">
              <a:spcBef>
                <a:spcPct val="20000"/>
              </a:spcBef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rgbClr val="AB7350"/>
              </a:buClr>
              <a:buSzPct val="110000"/>
              <a:buFont typeface="Wingdings" panose="05000000000000000000" pitchFamily="2" charset="2"/>
              <a:buChar char="§"/>
              <a:defRPr sz="2000">
                <a:solidFill>
                  <a:schemeClr val="tx1"/>
                </a:solidFill>
                <a:latin typeface="Cambria" panose="02040503050406030204" pitchFamily="18" charset="0"/>
                <a:ea typeface="HY견명조" panose="02030600000101010101" pitchFamily="18" charset="-127"/>
              </a:defRPr>
            </a:lvl9pPr>
          </a:lstStyle>
          <a:p>
            <a:pPr algn="r"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n-US" altLang="ko-KR" sz="1000" dirty="0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250</a:t>
            </a:r>
            <a:endParaRPr lang="ko-KR" altLang="en-US" sz="1000" dirty="0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70269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232576" y="7646963"/>
            <a:ext cx="639284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CHI activity assay of recombinant OsCHI3. The CHI activity of OsCHI3 was examined with 50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of naringenin chalcone or isoliquiritigenin. The CHI reactions for naringenin chalcone were performed with 0.1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OsCHI3 or without protein. The reactions were monitored at 2 min intervals. The CHI reactions for isoliquiritigenin were performed with 440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OsCHI3 or without protein. The reactions were monitored at 10 min intervals. Isomerization of chalcones to the corresponding flavanones led to a decrease in A</a:t>
            </a:r>
            <a:r>
              <a:rPr lang="en-US" altLang="ko-KR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90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pic>
        <p:nvPicPr>
          <p:cNvPr id="50" name="Picture 3">
            <a:extLst>
              <a:ext uri="{FF2B5EF4-FFF2-40B4-BE49-F238E27FC236}">
                <a16:creationId xmlns:a16="http://schemas.microsoft.com/office/drawing/2014/main" id="{82F3F565-AD2D-4661-A62D-82ECBB1319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49346" y="1824004"/>
            <a:ext cx="2694461" cy="2160000"/>
          </a:xfrm>
          <a:prstGeom prst="rect">
            <a:avLst/>
          </a:prstGeom>
          <a:noFill/>
          <a:ln/>
        </p:spPr>
      </p:pic>
      <p:pic>
        <p:nvPicPr>
          <p:cNvPr id="51" name="Picture 5">
            <a:extLst>
              <a:ext uri="{FF2B5EF4-FFF2-40B4-BE49-F238E27FC236}">
                <a16:creationId xmlns:a16="http://schemas.microsoft.com/office/drawing/2014/main" id="{510CD0B3-709F-41F4-B8B6-A42B4D2F262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17498" y="1824004"/>
            <a:ext cx="2694462" cy="2160000"/>
          </a:xfrm>
          <a:prstGeom prst="rect">
            <a:avLst/>
          </a:prstGeom>
          <a:noFill/>
          <a:ln/>
        </p:spPr>
      </p:pic>
      <p:pic>
        <p:nvPicPr>
          <p:cNvPr id="52" name="Picture 8">
            <a:extLst>
              <a:ext uri="{FF2B5EF4-FFF2-40B4-BE49-F238E27FC236}">
                <a16:creationId xmlns:a16="http://schemas.microsoft.com/office/drawing/2014/main" id="{F6DF65B4-ABBA-4551-BF9B-0023B44C30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17498" y="4077264"/>
            <a:ext cx="2694463" cy="2160000"/>
          </a:xfrm>
          <a:prstGeom prst="rect">
            <a:avLst/>
          </a:prstGeom>
          <a:noFill/>
          <a:ln/>
        </p:spPr>
      </p:pic>
      <p:pic>
        <p:nvPicPr>
          <p:cNvPr id="53" name="Picture 5">
            <a:extLst>
              <a:ext uri="{FF2B5EF4-FFF2-40B4-BE49-F238E27FC236}">
                <a16:creationId xmlns:a16="http://schemas.microsoft.com/office/drawing/2014/main" id="{90A07EDC-BF2A-4EA3-814E-E1C2852C957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49345" y="4077264"/>
            <a:ext cx="2694461" cy="2160000"/>
          </a:xfrm>
          <a:prstGeom prst="rect">
            <a:avLst/>
          </a:prstGeom>
          <a:noFill/>
          <a:ln/>
        </p:spPr>
      </p:pic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0532850"/>
              </p:ext>
            </p:extLst>
          </p:nvPr>
        </p:nvGraphicFramePr>
        <p:xfrm>
          <a:off x="220130" y="1399310"/>
          <a:ext cx="6412090" cy="4851674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9146">
                  <a:extLst>
                    <a:ext uri="{9D8B030D-6E8A-4147-A177-3AD203B41FA5}">
                      <a16:colId xmlns:a16="http://schemas.microsoft.com/office/drawing/2014/main" val="67317560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3618104211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1056228043"/>
                    </a:ext>
                  </a:extLst>
                </a:gridCol>
              </a:tblGrid>
              <a:tr h="344772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trat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CHI3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rote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20521414"/>
                  </a:ext>
                </a:extLst>
              </a:tr>
              <a:tr h="22534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ringenin chalcon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2023162"/>
                  </a:ext>
                </a:extLst>
              </a:tr>
              <a:tr h="225345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soliquiritigen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6523196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602085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6">
            <a:extLst>
              <a:ext uri="{FF2B5EF4-FFF2-40B4-BE49-F238E27FC236}">
                <a16:creationId xmlns:a16="http://schemas.microsoft.com/office/drawing/2014/main" id="{EFBD4C5E-BFA6-4D96-9FB7-AD80C9A6DE0A}"/>
              </a:ext>
            </a:extLst>
          </p:cNvPr>
          <p:cNvPicPr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10703" y="613110"/>
            <a:ext cx="2696400" cy="2160000"/>
          </a:xfrm>
          <a:prstGeom prst="rect">
            <a:avLst/>
          </a:prstGeom>
          <a:noFill/>
          <a:ln/>
        </p:spPr>
      </p:pic>
      <p:pic>
        <p:nvPicPr>
          <p:cNvPr id="25" name="Picture 8">
            <a:extLst>
              <a:ext uri="{FF2B5EF4-FFF2-40B4-BE49-F238E27FC236}">
                <a16:creationId xmlns:a16="http://schemas.microsoft.com/office/drawing/2014/main" id="{8C4130BA-A8FA-408B-AA19-BA09193ACB8F}"/>
              </a:ext>
            </a:extLst>
          </p:cNvPr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40612" y="613110"/>
            <a:ext cx="2696400" cy="2160000"/>
          </a:xfrm>
          <a:prstGeom prst="rect">
            <a:avLst/>
          </a:prstGeom>
          <a:noFill/>
          <a:ln/>
        </p:spPr>
      </p:pic>
      <p:pic>
        <p:nvPicPr>
          <p:cNvPr id="22" name="Picture 3">
            <a:extLst>
              <a:ext uri="{FF2B5EF4-FFF2-40B4-BE49-F238E27FC236}">
                <a16:creationId xmlns:a16="http://schemas.microsoft.com/office/drawing/2014/main" id="{C775142F-D4DB-4036-A501-19847804392A}"/>
              </a:ext>
            </a:extLst>
          </p:cNvPr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0703" y="5819582"/>
            <a:ext cx="26964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" name="Picture 12">
            <a:extLst>
              <a:ext uri="{FF2B5EF4-FFF2-40B4-BE49-F238E27FC236}">
                <a16:creationId xmlns:a16="http://schemas.microsoft.com/office/drawing/2014/main" id="{A93387D9-152E-486D-9EF3-59F26B5753F0}"/>
              </a:ext>
            </a:extLst>
          </p:cNvPr>
          <p:cNvPicPr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0612" y="5819582"/>
            <a:ext cx="2696400" cy="216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" name="Picture 5">
            <a:extLst>
              <a:ext uri="{FF2B5EF4-FFF2-40B4-BE49-F238E27FC236}">
                <a16:creationId xmlns:a16="http://schemas.microsoft.com/office/drawing/2014/main" id="{333F5F0F-ACCC-41FF-8C24-C4C7EE7840C7}"/>
              </a:ext>
            </a:extLst>
          </p:cNvPr>
          <p:cNvPicPr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340612" y="3217721"/>
            <a:ext cx="2696400" cy="2160000"/>
          </a:xfrm>
          <a:prstGeom prst="rect">
            <a:avLst/>
          </a:prstGeom>
          <a:noFill/>
          <a:ln/>
        </p:spPr>
      </p:pic>
      <p:pic>
        <p:nvPicPr>
          <p:cNvPr id="21" name="Picture 3">
            <a:extLst>
              <a:ext uri="{FF2B5EF4-FFF2-40B4-BE49-F238E27FC236}">
                <a16:creationId xmlns:a16="http://schemas.microsoft.com/office/drawing/2014/main" id="{2D613A7E-AEA0-473D-A273-7808E54B89DD}"/>
              </a:ext>
            </a:extLst>
          </p:cNvPr>
          <p:cNvPicPr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3910703" y="3217721"/>
            <a:ext cx="2696400" cy="2160000"/>
          </a:xfrm>
          <a:prstGeom prst="rect">
            <a:avLst/>
          </a:prstGeom>
          <a:noFill/>
          <a:ln/>
        </p:spPr>
      </p:pic>
      <p:sp>
        <p:nvSpPr>
          <p:cNvPr id="39" name="TextBox 38"/>
          <p:cNvSpPr txBox="1"/>
          <p:nvPr/>
        </p:nvSpPr>
        <p:spPr>
          <a:xfrm>
            <a:off x="213335" y="8093403"/>
            <a:ext cx="639284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CHI activity assay of recombinant OsCHI1, OsCHI6, and OsCHI7. The CHI activity for naringenin chalcone (50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) was examined through purification of OsCHI1, 6, and 7 proteins or without protein. The CHI reactions were carried out with 100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OsCHI1 or 500 </a:t>
            </a:r>
            <a:r>
              <a:rPr lang="el-GR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 of purified OsCHI6 and 7 proteins. The reactions were monitored at 2 min intervals.</a:t>
            </a: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5439391"/>
              </p:ext>
            </p:extLst>
          </p:nvPr>
        </p:nvGraphicFramePr>
        <p:xfrm>
          <a:off x="213335" y="262768"/>
          <a:ext cx="6412090" cy="248559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9146">
                  <a:extLst>
                    <a:ext uri="{9D8B030D-6E8A-4147-A177-3AD203B41FA5}">
                      <a16:colId xmlns:a16="http://schemas.microsoft.com/office/drawing/2014/main" val="67317560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3618104211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1056228043"/>
                    </a:ext>
                  </a:extLst>
                </a:gridCol>
              </a:tblGrid>
              <a:tr h="32982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trat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CHI1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rote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20521414"/>
                  </a:ext>
                </a:extLst>
              </a:tr>
              <a:tr h="21557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ringenin chalcon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2023162"/>
                  </a:ext>
                </a:extLst>
              </a:tr>
            </a:tbl>
          </a:graphicData>
        </a:graphic>
      </p:graphicFrame>
      <p:graphicFrame>
        <p:nvGraphicFramePr>
          <p:cNvPr id="16" name="표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714023"/>
              </p:ext>
            </p:extLst>
          </p:nvPr>
        </p:nvGraphicFramePr>
        <p:xfrm>
          <a:off x="213335" y="2863903"/>
          <a:ext cx="6412090" cy="248559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9146">
                  <a:extLst>
                    <a:ext uri="{9D8B030D-6E8A-4147-A177-3AD203B41FA5}">
                      <a16:colId xmlns:a16="http://schemas.microsoft.com/office/drawing/2014/main" val="67317560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3618104211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1056228043"/>
                    </a:ext>
                  </a:extLst>
                </a:gridCol>
              </a:tblGrid>
              <a:tr h="32982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trat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CHI6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rote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20521414"/>
                  </a:ext>
                </a:extLst>
              </a:tr>
              <a:tr h="21557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ringenin chalcon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2023162"/>
                  </a:ext>
                </a:extLst>
              </a:tr>
            </a:tbl>
          </a:graphicData>
        </a:graphic>
      </p:graphicFrame>
      <p:graphicFrame>
        <p:nvGraphicFramePr>
          <p:cNvPr id="19" name="표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8275546"/>
              </p:ext>
            </p:extLst>
          </p:nvPr>
        </p:nvGraphicFramePr>
        <p:xfrm>
          <a:off x="213335" y="5464523"/>
          <a:ext cx="6412090" cy="248559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9146">
                  <a:extLst>
                    <a:ext uri="{9D8B030D-6E8A-4147-A177-3AD203B41FA5}">
                      <a16:colId xmlns:a16="http://schemas.microsoft.com/office/drawing/2014/main" val="67317560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3618104211"/>
                    </a:ext>
                  </a:extLst>
                </a:gridCol>
                <a:gridCol w="2591472">
                  <a:extLst>
                    <a:ext uri="{9D8B030D-6E8A-4147-A177-3AD203B41FA5}">
                      <a16:colId xmlns:a16="http://schemas.microsoft.com/office/drawing/2014/main" val="1056228043"/>
                    </a:ext>
                  </a:extLst>
                </a:gridCol>
              </a:tblGrid>
              <a:tr h="329827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strat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CHI7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protein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320521414"/>
                  </a:ext>
                </a:extLst>
              </a:tr>
              <a:tr h="2155771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ringenin chalcone</a:t>
                      </a:r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5202316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855811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8" name="Chart 3" title="Chart">
            <a:extLst>
              <a:ext uri="{FF2B5EF4-FFF2-40B4-BE49-F238E27FC236}">
                <a16:creationId xmlns:a16="http://schemas.microsoft.com/office/drawing/2014/main" id="{00000000-0008-0000-06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6942376"/>
              </p:ext>
            </p:extLst>
          </p:nvPr>
        </p:nvGraphicFramePr>
        <p:xfrm>
          <a:off x="406993" y="4760210"/>
          <a:ext cx="2965751" cy="17079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7" name="Chart 3" title="Chart">
            <a:extLst>
              <a:ext uri="{FF2B5EF4-FFF2-40B4-BE49-F238E27FC236}">
                <a16:creationId xmlns:a16="http://schemas.microsoft.com/office/drawing/2014/main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9513782"/>
              </p:ext>
            </p:extLst>
          </p:nvPr>
        </p:nvGraphicFramePr>
        <p:xfrm>
          <a:off x="3621503" y="3424307"/>
          <a:ext cx="2965751" cy="170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3" name="Chart 3" title="Chart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4211406"/>
              </p:ext>
            </p:extLst>
          </p:nvPr>
        </p:nvGraphicFramePr>
        <p:xfrm>
          <a:off x="3621503" y="746171"/>
          <a:ext cx="2965751" cy="169716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4" name="Chart 3" title="Chart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9684152"/>
              </p:ext>
            </p:extLst>
          </p:nvPr>
        </p:nvGraphicFramePr>
        <p:xfrm>
          <a:off x="405803" y="2090091"/>
          <a:ext cx="2966942" cy="170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5" name="Chart 3" title="Chart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733908"/>
              </p:ext>
            </p:extLst>
          </p:nvPr>
        </p:nvGraphicFramePr>
        <p:xfrm>
          <a:off x="3621503" y="2090090"/>
          <a:ext cx="2965751" cy="17028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6" name="Chart 3" title="Chart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17040"/>
              </p:ext>
            </p:extLst>
          </p:nvPr>
        </p:nvGraphicFramePr>
        <p:xfrm>
          <a:off x="406993" y="3424307"/>
          <a:ext cx="2965751" cy="170268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2" name="Chart 3" title="Chart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6248431"/>
              </p:ext>
            </p:extLst>
          </p:nvPr>
        </p:nvGraphicFramePr>
        <p:xfrm>
          <a:off x="405803" y="746171"/>
          <a:ext cx="2966942" cy="170166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7" name="TextBox 36">
            <a:extLst>
              <a:ext uri="{FF2B5EF4-FFF2-40B4-BE49-F238E27FC236}">
                <a16:creationId xmlns:a16="http://schemas.microsoft.com/office/drawing/2014/main" id="{4985FCE1-73B8-4B31-80BD-7F352C654843}"/>
              </a:ext>
            </a:extLst>
          </p:cNvPr>
          <p:cNvSpPr txBox="1"/>
          <p:nvPr/>
        </p:nvSpPr>
        <p:spPr>
          <a:xfrm>
            <a:off x="362852" y="2180596"/>
            <a:ext cx="353943" cy="256403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rtl="0">
              <a:defRPr sz="10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100" dirty="0"/>
              <a:t>Relative expression/</a:t>
            </a:r>
            <a:r>
              <a:rPr lang="en-US" altLang="ko-KR" sz="1100" i="1" dirty="0"/>
              <a:t>OsUBQ1</a:t>
            </a:r>
            <a:endParaRPr lang="x-none" altLang="ko-KR" sz="1100" i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42BCA79-5D76-4A23-ADDE-93E0B1A4F0E4}"/>
              </a:ext>
            </a:extLst>
          </p:cNvPr>
          <p:cNvSpPr txBox="1"/>
          <p:nvPr/>
        </p:nvSpPr>
        <p:spPr>
          <a:xfrm>
            <a:off x="3632862" y="1513665"/>
            <a:ext cx="353943" cy="2564035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rtl="0">
              <a:defRPr sz="10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100" b="0" dirty="0"/>
              <a:t>Relative expression/</a:t>
            </a:r>
            <a:r>
              <a:rPr lang="en-US" altLang="ko-KR" sz="1100" b="0" i="1" dirty="0"/>
              <a:t>OsUBQ1</a:t>
            </a:r>
            <a:endParaRPr lang="x-none" altLang="ko-KR" sz="1100" b="0" i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295698BF-EC8A-4902-B727-C425DF9CECBA}"/>
              </a:ext>
            </a:extLst>
          </p:cNvPr>
          <p:cNvSpPr txBox="1"/>
          <p:nvPr/>
        </p:nvSpPr>
        <p:spPr>
          <a:xfrm>
            <a:off x="1107132" y="811748"/>
            <a:ext cx="6652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1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95BF527-DDD5-4271-8396-9932805FCA47}"/>
              </a:ext>
            </a:extLst>
          </p:cNvPr>
          <p:cNvSpPr txBox="1"/>
          <p:nvPr/>
        </p:nvSpPr>
        <p:spPr>
          <a:xfrm>
            <a:off x="4314794" y="811748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2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DCDA0BA-921B-41D8-9E32-E7F20CAD4C42}"/>
              </a:ext>
            </a:extLst>
          </p:cNvPr>
          <p:cNvSpPr txBox="1"/>
          <p:nvPr/>
        </p:nvSpPr>
        <p:spPr>
          <a:xfrm>
            <a:off x="1107132" y="2156508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3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CE2745C-C323-4B83-A4BF-4E1F83EA6260}"/>
              </a:ext>
            </a:extLst>
          </p:cNvPr>
          <p:cNvSpPr txBox="1"/>
          <p:nvPr/>
        </p:nvSpPr>
        <p:spPr>
          <a:xfrm>
            <a:off x="4314794" y="2156508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4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A8E8076-AB37-4AD0-81AE-DABEDA22423A}"/>
              </a:ext>
            </a:extLst>
          </p:cNvPr>
          <p:cNvSpPr txBox="1"/>
          <p:nvPr/>
        </p:nvSpPr>
        <p:spPr>
          <a:xfrm>
            <a:off x="1107132" y="3482232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5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D3ECD29-A049-4481-8AE0-A465BC1DC13F}"/>
              </a:ext>
            </a:extLst>
          </p:cNvPr>
          <p:cNvSpPr txBox="1"/>
          <p:nvPr/>
        </p:nvSpPr>
        <p:spPr>
          <a:xfrm>
            <a:off x="4281695" y="3477970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6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9E01EB-8719-4534-8F16-403915C0F475}"/>
              </a:ext>
            </a:extLst>
          </p:cNvPr>
          <p:cNvSpPr txBox="1"/>
          <p:nvPr/>
        </p:nvSpPr>
        <p:spPr>
          <a:xfrm>
            <a:off x="1107132" y="4816359"/>
            <a:ext cx="7967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7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1060774" y="6024548"/>
            <a:ext cx="408694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h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A7A21F0-AB0A-4DE1-B7D1-F3949634D611}"/>
              </a:ext>
            </a:extLst>
          </p:cNvPr>
          <p:cNvSpPr txBox="1"/>
          <p:nvPr/>
        </p:nvSpPr>
        <p:spPr>
          <a:xfrm>
            <a:off x="1100712" y="6199071"/>
            <a:ext cx="676109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eedling            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0BB7CA8-8C4F-414F-BDB8-D700B1F1643E}"/>
              </a:ext>
            </a:extLst>
          </p:cNvPr>
          <p:cNvSpPr txBox="1"/>
          <p:nvPr/>
        </p:nvSpPr>
        <p:spPr>
          <a:xfrm>
            <a:off x="1931781" y="6199071"/>
            <a:ext cx="780716" cy="31892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Vegetative growth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8AF8CC0-EE3F-44FD-BAFB-B7FCB3CB48BD}"/>
              </a:ext>
            </a:extLst>
          </p:cNvPr>
          <p:cNvSpPr txBox="1"/>
          <p:nvPr/>
        </p:nvSpPr>
        <p:spPr>
          <a:xfrm>
            <a:off x="2669448" y="6199071"/>
            <a:ext cx="786956" cy="31892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eproductive</a:t>
            </a:r>
          </a:p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12">
            <a:extLst>
              <a:ext uri="{FF2B5EF4-FFF2-40B4-BE49-F238E27FC236}">
                <a16:creationId xmlns:a16="http://schemas.microsoft.com/office/drawing/2014/main" id="{F852F778-F223-454B-92DB-CD0C367D7214}"/>
              </a:ext>
            </a:extLst>
          </p:cNvPr>
          <p:cNvCxnSpPr>
            <a:cxnSpLocks/>
          </p:cNvCxnSpPr>
          <p:nvPr/>
        </p:nvCxnSpPr>
        <p:spPr>
          <a:xfrm>
            <a:off x="2896685" y="6205421"/>
            <a:ext cx="33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12">
            <a:extLst>
              <a:ext uri="{FF2B5EF4-FFF2-40B4-BE49-F238E27FC236}">
                <a16:creationId xmlns:a16="http://schemas.microsoft.com/office/drawing/2014/main" id="{BAB77281-BB58-4EA4-B78D-5255CFEE3801}"/>
              </a:ext>
            </a:extLst>
          </p:cNvPr>
          <p:cNvCxnSpPr>
            <a:cxnSpLocks/>
          </p:cNvCxnSpPr>
          <p:nvPr/>
        </p:nvCxnSpPr>
        <p:spPr>
          <a:xfrm>
            <a:off x="1817552" y="6205421"/>
            <a:ext cx="10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12">
            <a:extLst>
              <a:ext uri="{FF2B5EF4-FFF2-40B4-BE49-F238E27FC236}">
                <a16:creationId xmlns:a16="http://schemas.microsoft.com/office/drawing/2014/main" id="{0C1B50BC-01CD-478D-9054-03D3BFDA87BB}"/>
              </a:ext>
            </a:extLst>
          </p:cNvPr>
          <p:cNvCxnSpPr>
            <a:cxnSpLocks/>
          </p:cNvCxnSpPr>
          <p:nvPr/>
        </p:nvCxnSpPr>
        <p:spPr>
          <a:xfrm>
            <a:off x="1097006" y="6205421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1449025" y="6024548"/>
            <a:ext cx="346533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1810442" y="6024548"/>
            <a:ext cx="345277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2186102" y="6024548"/>
            <a:ext cx="345277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tem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2526086" y="6024548"/>
            <a:ext cx="346533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2848169" y="6033923"/>
            <a:ext cx="423746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nicl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4267524" y="4691598"/>
            <a:ext cx="408694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h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5A7A21F0-AB0A-4DE1-B7D1-F3949634D611}"/>
              </a:ext>
            </a:extLst>
          </p:cNvPr>
          <p:cNvSpPr txBox="1"/>
          <p:nvPr/>
        </p:nvSpPr>
        <p:spPr>
          <a:xfrm>
            <a:off x="4307462" y="4866121"/>
            <a:ext cx="676109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eedling             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0BB7CA8-8C4F-414F-BDB8-D700B1F1643E}"/>
              </a:ext>
            </a:extLst>
          </p:cNvPr>
          <p:cNvSpPr txBox="1"/>
          <p:nvPr/>
        </p:nvSpPr>
        <p:spPr>
          <a:xfrm>
            <a:off x="5138531" y="4866121"/>
            <a:ext cx="780716" cy="31892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Vegetative growth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18AF8CC0-EE3F-44FD-BAFB-B7FCB3CB48BD}"/>
              </a:ext>
            </a:extLst>
          </p:cNvPr>
          <p:cNvSpPr txBox="1"/>
          <p:nvPr/>
        </p:nvSpPr>
        <p:spPr>
          <a:xfrm>
            <a:off x="5876198" y="4866121"/>
            <a:ext cx="786956" cy="31892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eproductive</a:t>
            </a:r>
          </a:p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growth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12">
            <a:extLst>
              <a:ext uri="{FF2B5EF4-FFF2-40B4-BE49-F238E27FC236}">
                <a16:creationId xmlns:a16="http://schemas.microsoft.com/office/drawing/2014/main" id="{F852F778-F223-454B-92DB-CD0C367D7214}"/>
              </a:ext>
            </a:extLst>
          </p:cNvPr>
          <p:cNvCxnSpPr>
            <a:cxnSpLocks/>
          </p:cNvCxnSpPr>
          <p:nvPr/>
        </p:nvCxnSpPr>
        <p:spPr>
          <a:xfrm>
            <a:off x="6103435" y="4872471"/>
            <a:ext cx="3312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12">
            <a:extLst>
              <a:ext uri="{FF2B5EF4-FFF2-40B4-BE49-F238E27FC236}">
                <a16:creationId xmlns:a16="http://schemas.microsoft.com/office/drawing/2014/main" id="{BAB77281-BB58-4EA4-B78D-5255CFEE3801}"/>
              </a:ext>
            </a:extLst>
          </p:cNvPr>
          <p:cNvCxnSpPr>
            <a:cxnSpLocks/>
          </p:cNvCxnSpPr>
          <p:nvPr/>
        </p:nvCxnSpPr>
        <p:spPr>
          <a:xfrm>
            <a:off x="5024302" y="4872471"/>
            <a:ext cx="10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12">
            <a:extLst>
              <a:ext uri="{FF2B5EF4-FFF2-40B4-BE49-F238E27FC236}">
                <a16:creationId xmlns:a16="http://schemas.microsoft.com/office/drawing/2014/main" id="{0C1B50BC-01CD-478D-9054-03D3BFDA87BB}"/>
              </a:ext>
            </a:extLst>
          </p:cNvPr>
          <p:cNvCxnSpPr>
            <a:cxnSpLocks/>
          </p:cNvCxnSpPr>
          <p:nvPr/>
        </p:nvCxnSpPr>
        <p:spPr>
          <a:xfrm>
            <a:off x="4303756" y="4872471"/>
            <a:ext cx="68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80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4655775" y="4691598"/>
            <a:ext cx="346533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5017192" y="4691598"/>
            <a:ext cx="345277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5392852" y="4691598"/>
            <a:ext cx="345277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Stem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5732836" y="4691598"/>
            <a:ext cx="346533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DF5A5985-3D85-4794-BEB2-514CC8ADCD7A}"/>
              </a:ext>
            </a:extLst>
          </p:cNvPr>
          <p:cNvSpPr txBox="1"/>
          <p:nvPr/>
        </p:nvSpPr>
        <p:spPr>
          <a:xfrm>
            <a:off x="6054919" y="4700973"/>
            <a:ext cx="423746" cy="195814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ctr"/>
            <a:r>
              <a:rPr lang="en-US" altLang="ko-KR" sz="800" dirty="0">
                <a:latin typeface="Arial" panose="020B0604020202020204" pitchFamily="34" charset="0"/>
                <a:cs typeface="Arial" panose="020B0604020202020204" pitchFamily="34" charset="0"/>
              </a:rPr>
              <a:t>Panicle</a:t>
            </a:r>
            <a:endParaRPr lang="ko-KR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2387993" y="217412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2235244" y="227316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029793" y="237650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448437" y="2273167"/>
            <a:ext cx="296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629992" y="237650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370917" y="5062536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2549117" y="5159809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2729117" y="525107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자유형 29"/>
          <p:cNvSpPr/>
          <p:nvPr/>
        </p:nvSpPr>
        <p:spPr>
          <a:xfrm>
            <a:off x="1255952" y="5017154"/>
            <a:ext cx="1800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6" name="자유형 145"/>
          <p:cNvSpPr/>
          <p:nvPr/>
        </p:nvSpPr>
        <p:spPr>
          <a:xfrm>
            <a:off x="1623152" y="5110377"/>
            <a:ext cx="1432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7" name="자유형 146"/>
          <p:cNvSpPr/>
          <p:nvPr/>
        </p:nvSpPr>
        <p:spPr>
          <a:xfrm>
            <a:off x="1979552" y="5203600"/>
            <a:ext cx="10764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8" name="자유형 147"/>
          <p:cNvSpPr/>
          <p:nvPr/>
        </p:nvSpPr>
        <p:spPr>
          <a:xfrm>
            <a:off x="2335952" y="5297723"/>
            <a:ext cx="720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9" name="자유형 148"/>
          <p:cNvSpPr/>
          <p:nvPr/>
        </p:nvSpPr>
        <p:spPr>
          <a:xfrm>
            <a:off x="2695952" y="5390917"/>
            <a:ext cx="360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1" name="TextBox 150"/>
          <p:cNvSpPr txBox="1"/>
          <p:nvPr/>
        </p:nvSpPr>
        <p:spPr>
          <a:xfrm>
            <a:off x="2192717" y="4966862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012717" y="487626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자유형 152"/>
          <p:cNvSpPr/>
          <p:nvPr/>
        </p:nvSpPr>
        <p:spPr>
          <a:xfrm>
            <a:off x="2016428" y="2316598"/>
            <a:ext cx="103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4" name="자유형 153"/>
          <p:cNvSpPr/>
          <p:nvPr/>
        </p:nvSpPr>
        <p:spPr>
          <a:xfrm>
            <a:off x="2016428" y="2422897"/>
            <a:ext cx="67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5" name="자유형 154"/>
          <p:cNvSpPr/>
          <p:nvPr/>
        </p:nvSpPr>
        <p:spPr>
          <a:xfrm>
            <a:off x="2016428" y="2521526"/>
            <a:ext cx="3204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6" name="자유형 155"/>
          <p:cNvSpPr/>
          <p:nvPr/>
        </p:nvSpPr>
        <p:spPr>
          <a:xfrm>
            <a:off x="1614827" y="2521526"/>
            <a:ext cx="32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7" name="자유형 156"/>
          <p:cNvSpPr/>
          <p:nvPr/>
        </p:nvSpPr>
        <p:spPr>
          <a:xfrm>
            <a:off x="1254827" y="2422897"/>
            <a:ext cx="68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8" name="TextBox 157"/>
          <p:cNvSpPr txBox="1"/>
          <p:nvPr/>
        </p:nvSpPr>
        <p:spPr>
          <a:xfrm>
            <a:off x="4847305" y="4045649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자유형 158"/>
          <p:cNvSpPr/>
          <p:nvPr/>
        </p:nvSpPr>
        <p:spPr>
          <a:xfrm>
            <a:off x="4832140" y="4185085"/>
            <a:ext cx="32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0" name="TextBox 159"/>
          <p:cNvSpPr txBox="1"/>
          <p:nvPr/>
        </p:nvSpPr>
        <p:spPr>
          <a:xfrm>
            <a:off x="5793623" y="3777787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자유형 160"/>
          <p:cNvSpPr/>
          <p:nvPr/>
        </p:nvSpPr>
        <p:spPr>
          <a:xfrm>
            <a:off x="5551407" y="3918876"/>
            <a:ext cx="7236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2" name="TextBox 161"/>
          <p:cNvSpPr txBox="1"/>
          <p:nvPr/>
        </p:nvSpPr>
        <p:spPr>
          <a:xfrm>
            <a:off x="5966172" y="3980024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자유형 162"/>
          <p:cNvSpPr/>
          <p:nvPr/>
        </p:nvSpPr>
        <p:spPr>
          <a:xfrm>
            <a:off x="5951007" y="4119967"/>
            <a:ext cx="32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4" name="TextBox 163"/>
          <p:cNvSpPr txBox="1"/>
          <p:nvPr/>
        </p:nvSpPr>
        <p:spPr>
          <a:xfrm>
            <a:off x="5205330" y="3874265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자유형 164"/>
          <p:cNvSpPr/>
          <p:nvPr/>
        </p:nvSpPr>
        <p:spPr>
          <a:xfrm>
            <a:off x="4833765" y="4016716"/>
            <a:ext cx="103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6" name="자유형 165"/>
          <p:cNvSpPr/>
          <p:nvPr/>
        </p:nvSpPr>
        <p:spPr>
          <a:xfrm>
            <a:off x="4473765" y="3714806"/>
            <a:ext cx="14364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7" name="TextBox 166"/>
          <p:cNvSpPr txBox="1"/>
          <p:nvPr/>
        </p:nvSpPr>
        <p:spPr>
          <a:xfrm>
            <a:off x="5045130" y="3571291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5588172" y="3671107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자유형 168"/>
          <p:cNvSpPr/>
          <p:nvPr/>
        </p:nvSpPr>
        <p:spPr>
          <a:xfrm>
            <a:off x="5195007" y="3817251"/>
            <a:ext cx="1080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7" name="TextBox 86"/>
          <p:cNvSpPr txBox="1"/>
          <p:nvPr/>
        </p:nvSpPr>
        <p:spPr>
          <a:xfrm>
            <a:off x="5250210" y="239851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자유형 87"/>
          <p:cNvSpPr/>
          <p:nvPr/>
        </p:nvSpPr>
        <p:spPr>
          <a:xfrm>
            <a:off x="5235045" y="2538461"/>
            <a:ext cx="32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9" name="TextBox 88"/>
          <p:cNvSpPr txBox="1"/>
          <p:nvPr/>
        </p:nvSpPr>
        <p:spPr>
          <a:xfrm>
            <a:off x="5606610" y="2295182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자유형 89"/>
          <p:cNvSpPr/>
          <p:nvPr/>
        </p:nvSpPr>
        <p:spPr>
          <a:xfrm>
            <a:off x="5235045" y="2437330"/>
            <a:ext cx="103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1" name="TextBox 90"/>
          <p:cNvSpPr txBox="1"/>
          <p:nvPr/>
        </p:nvSpPr>
        <p:spPr>
          <a:xfrm>
            <a:off x="213335" y="7685601"/>
            <a:ext cx="639284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analysis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 in rice seedlings and different tissues. A ubiquitin gene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UBQ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amplified using specific primers and was used as an internal control. Expression level of each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is presented as the relative expression compared to the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UBQ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. Asterisks indicate significant differences (*;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;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5, Tukey’s HSD-test). 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2386937" y="984099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2054188" y="1093785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450556" y="984099"/>
            <a:ext cx="296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657562" y="1093785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자유형 102"/>
          <p:cNvSpPr/>
          <p:nvPr/>
        </p:nvSpPr>
        <p:spPr>
          <a:xfrm>
            <a:off x="2015372" y="1125361"/>
            <a:ext cx="103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5" name="자유형 104"/>
          <p:cNvSpPr/>
          <p:nvPr/>
        </p:nvSpPr>
        <p:spPr>
          <a:xfrm>
            <a:off x="2015372" y="1232458"/>
            <a:ext cx="316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6" name="자유형 105"/>
          <p:cNvSpPr/>
          <p:nvPr/>
        </p:nvSpPr>
        <p:spPr>
          <a:xfrm>
            <a:off x="1613346" y="1232458"/>
            <a:ext cx="3276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7" name="자유형 106"/>
          <p:cNvSpPr/>
          <p:nvPr/>
        </p:nvSpPr>
        <p:spPr>
          <a:xfrm>
            <a:off x="1256946" y="1125361"/>
            <a:ext cx="68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08" name="TextBox 107"/>
          <p:cNvSpPr txBox="1"/>
          <p:nvPr/>
        </p:nvSpPr>
        <p:spPr>
          <a:xfrm>
            <a:off x="4665750" y="2295182"/>
            <a:ext cx="2967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874556" y="2398518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자유형 114"/>
          <p:cNvSpPr/>
          <p:nvPr/>
        </p:nvSpPr>
        <p:spPr>
          <a:xfrm>
            <a:off x="4832140" y="2538461"/>
            <a:ext cx="32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6" name="자유형 115"/>
          <p:cNvSpPr/>
          <p:nvPr/>
        </p:nvSpPr>
        <p:spPr>
          <a:xfrm>
            <a:off x="4472140" y="2437330"/>
            <a:ext cx="68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17" name="TextBox 116"/>
          <p:cNvSpPr txBox="1"/>
          <p:nvPr/>
        </p:nvSpPr>
        <p:spPr>
          <a:xfrm>
            <a:off x="5972261" y="2543294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자유형 117"/>
          <p:cNvSpPr/>
          <p:nvPr/>
        </p:nvSpPr>
        <p:spPr>
          <a:xfrm>
            <a:off x="5911845" y="2683536"/>
            <a:ext cx="360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1" name="TextBox 120"/>
          <p:cNvSpPr txBox="1"/>
          <p:nvPr/>
        </p:nvSpPr>
        <p:spPr>
          <a:xfrm>
            <a:off x="4667305" y="3777787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자유형 121"/>
          <p:cNvSpPr/>
          <p:nvPr/>
        </p:nvSpPr>
        <p:spPr>
          <a:xfrm>
            <a:off x="4472140" y="3920378"/>
            <a:ext cx="6840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3" name="TextBox 122"/>
          <p:cNvSpPr txBox="1"/>
          <p:nvPr/>
        </p:nvSpPr>
        <p:spPr>
          <a:xfrm>
            <a:off x="5253677" y="4045649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자유형 123"/>
          <p:cNvSpPr/>
          <p:nvPr/>
        </p:nvSpPr>
        <p:spPr>
          <a:xfrm>
            <a:off x="5232861" y="4185085"/>
            <a:ext cx="280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5" name="TextBox 124"/>
          <p:cNvSpPr txBox="1"/>
          <p:nvPr/>
        </p:nvSpPr>
        <p:spPr>
          <a:xfrm>
            <a:off x="5610581" y="3980024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자유형 125"/>
          <p:cNvSpPr/>
          <p:nvPr/>
        </p:nvSpPr>
        <p:spPr>
          <a:xfrm>
            <a:off x="5589765" y="4119967"/>
            <a:ext cx="280800" cy="72000"/>
          </a:xfrm>
          <a:custGeom>
            <a:avLst/>
            <a:gdLst>
              <a:gd name="connsiteX0" fmla="*/ 0 w 2779183"/>
              <a:gd name="connsiteY0" fmla="*/ 160866 h 160866"/>
              <a:gd name="connsiteX1" fmla="*/ 0 w 2779183"/>
              <a:gd name="connsiteY1" fmla="*/ 0 h 160866"/>
              <a:gd name="connsiteX2" fmla="*/ 2779183 w 2779183"/>
              <a:gd name="connsiteY2" fmla="*/ 0 h 160866"/>
              <a:gd name="connsiteX3" fmla="*/ 2779183 w 2779183"/>
              <a:gd name="connsiteY3" fmla="*/ 160866 h 1608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2779183" h="160866">
                <a:moveTo>
                  <a:pt x="0" y="160866"/>
                </a:moveTo>
                <a:lnTo>
                  <a:pt x="0" y="0"/>
                </a:lnTo>
                <a:lnTo>
                  <a:pt x="2779183" y="0"/>
                </a:lnTo>
                <a:lnTo>
                  <a:pt x="2779183" y="160866"/>
                </a:lnTo>
              </a:path>
            </a:pathLst>
          </a:cu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49101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 rotWithShape="1">
          <a:blip r:embed="rId2"/>
          <a:srcRect t="16610" r="1896"/>
          <a:stretch/>
        </p:blipFill>
        <p:spPr>
          <a:xfrm>
            <a:off x="1441651" y="2091025"/>
            <a:ext cx="4181745" cy="149027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3"/>
          <a:srcRect t="16387" r="1896"/>
          <a:stretch/>
        </p:blipFill>
        <p:spPr>
          <a:xfrm>
            <a:off x="1441651" y="3870629"/>
            <a:ext cx="4181745" cy="149425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008327" y="3454342"/>
            <a:ext cx="1335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etention time (min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402207" y="1929383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화살표 연결선 17"/>
          <p:cNvCxnSpPr/>
          <p:nvPr/>
        </p:nvCxnSpPr>
        <p:spPr>
          <a:xfrm>
            <a:off x="4898130" y="2359846"/>
            <a:ext cx="0" cy="50400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4469968" y="2112633"/>
            <a:ext cx="8563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kuranetin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13075" y="1847503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402207" y="3711298"/>
            <a:ext cx="4411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>
                <a:latin typeface="Arial" panose="020B0604020202020204" pitchFamily="34" charset="0"/>
                <a:cs typeface="Arial" panose="020B0604020202020204" pitchFamily="34" charset="0"/>
              </a:rPr>
              <a:t>mAU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3008327" y="5241770"/>
            <a:ext cx="13356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 dirty="0">
                <a:latin typeface="Arial" panose="020B0604020202020204" pitchFamily="34" charset="0"/>
                <a:cs typeface="Arial" panose="020B0604020202020204" pitchFamily="34" charset="0"/>
              </a:rPr>
              <a:t>Retention time (min)</a:t>
            </a:r>
            <a:endParaRPr lang="ko-KR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13075" y="363989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3335" y="8093403"/>
            <a:ext cx="63928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HPLC analysis of UV-treated (a) and untreated (b) rice leaves. Phenolic fractions were obtained from rice leaves 2 days after UV-treatment and analyzed with HPLC. </a:t>
            </a:r>
          </a:p>
        </p:txBody>
      </p:sp>
    </p:spTree>
    <p:extLst>
      <p:ext uri="{BB962C8B-B14F-4D97-AF65-F5344CB8AC3E}">
        <p14:creationId xmlns:p14="http://schemas.microsoft.com/office/powerpoint/2010/main" val="356951919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Chart 3" title="Chart">
            <a:extLst>
              <a:ext uri="{FF2B5EF4-FFF2-40B4-BE49-F238E27FC236}">
                <a16:creationId xmlns:a16="http://schemas.microsoft.com/office/drawing/2014/main" id="{00000000-0008-0000-06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8596885"/>
              </p:ext>
            </p:extLst>
          </p:nvPr>
        </p:nvGraphicFramePr>
        <p:xfrm>
          <a:off x="666854" y="4694872"/>
          <a:ext cx="2640050" cy="18266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7" name="Chart 3" title="Chart">
            <a:extLst>
              <a:ext uri="{FF2B5EF4-FFF2-40B4-BE49-F238E27FC236}">
                <a16:creationId xmlns:a16="http://schemas.microsoft.com/office/drawing/2014/main" id="{00000000-0008-0000-04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6260946"/>
              </p:ext>
            </p:extLst>
          </p:nvPr>
        </p:nvGraphicFramePr>
        <p:xfrm>
          <a:off x="660628" y="3369406"/>
          <a:ext cx="2640050" cy="18234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6" name="Chart 3" title="Chart">
            <a:extLst>
              <a:ext uri="{FF2B5EF4-FFF2-40B4-BE49-F238E27FC236}">
                <a16:creationId xmlns:a16="http://schemas.microsoft.com/office/drawing/2014/main" id="{00000000-0008-0000-03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4508364"/>
              </p:ext>
            </p:extLst>
          </p:nvPr>
        </p:nvGraphicFramePr>
        <p:xfrm>
          <a:off x="3825537" y="2038336"/>
          <a:ext cx="2640050" cy="18201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4" name="Chart 3" title="Chart">
            <a:extLst>
              <a:ext uri="{FF2B5EF4-FFF2-40B4-BE49-F238E27FC236}">
                <a16:creationId xmlns:a16="http://schemas.microsoft.com/office/drawing/2014/main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2485386"/>
              </p:ext>
            </p:extLst>
          </p:nvPr>
        </p:nvGraphicFramePr>
        <p:xfrm>
          <a:off x="654402" y="2037188"/>
          <a:ext cx="2640050" cy="18220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3" name="Chart 3" title="Chart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18750201"/>
              </p:ext>
            </p:extLst>
          </p:nvPr>
        </p:nvGraphicFramePr>
        <p:xfrm>
          <a:off x="3819203" y="694062"/>
          <a:ext cx="2640050" cy="18309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2" name="Chart 3" title="Chart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2472934"/>
              </p:ext>
            </p:extLst>
          </p:nvPr>
        </p:nvGraphicFramePr>
        <p:xfrm>
          <a:off x="656557" y="699004"/>
          <a:ext cx="2640050" cy="18260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5" name="Chart 3" title="Chart">
            <a:extLst>
              <a:ext uri="{FF2B5EF4-FFF2-40B4-BE49-F238E27FC236}">
                <a16:creationId xmlns:a16="http://schemas.microsoft.com/office/drawing/2014/main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1673457"/>
              </p:ext>
            </p:extLst>
          </p:nvPr>
        </p:nvGraphicFramePr>
        <p:xfrm>
          <a:off x="3806445" y="699006"/>
          <a:ext cx="2640050" cy="179534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9" name="TextBox 68">
            <a:extLst>
              <a:ext uri="{FF2B5EF4-FFF2-40B4-BE49-F238E27FC236}">
                <a16:creationId xmlns:a16="http://schemas.microsoft.com/office/drawing/2014/main" id="{CC91C4E9-A64F-41F6-8851-8042A00D67E3}"/>
              </a:ext>
            </a:extLst>
          </p:cNvPr>
          <p:cNvSpPr txBox="1"/>
          <p:nvPr/>
        </p:nvSpPr>
        <p:spPr>
          <a:xfrm>
            <a:off x="334874" y="2286536"/>
            <a:ext cx="369332" cy="2233781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rtl="0">
              <a:defRPr sz="10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200" b="0" dirty="0"/>
              <a:t>Relative expression/</a:t>
            </a:r>
            <a:r>
              <a:rPr lang="en-US" altLang="ko-KR" sz="1200" b="0" i="1" dirty="0"/>
              <a:t>OsUBQ1</a:t>
            </a:r>
            <a:endParaRPr lang="x-none" altLang="ko-KR" sz="1200" b="0" i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75A95FC4-66C9-4932-BFBC-96E8D6FF2FED}"/>
              </a:ext>
            </a:extLst>
          </p:cNvPr>
          <p:cNvSpPr txBox="1"/>
          <p:nvPr/>
        </p:nvSpPr>
        <p:spPr>
          <a:xfrm>
            <a:off x="2404758" y="1407070"/>
            <a:ext cx="299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F51350B2-804B-48F9-BE49-4D093DA319EC}"/>
              </a:ext>
            </a:extLst>
          </p:cNvPr>
          <p:cNvSpPr txBox="1"/>
          <p:nvPr/>
        </p:nvSpPr>
        <p:spPr>
          <a:xfrm>
            <a:off x="2820138" y="1480363"/>
            <a:ext cx="2990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812A3C7-2560-4DF8-845F-791268A6AB1D}"/>
              </a:ext>
            </a:extLst>
          </p:cNvPr>
          <p:cNvSpPr txBox="1"/>
          <p:nvPr/>
        </p:nvSpPr>
        <p:spPr>
          <a:xfrm>
            <a:off x="3511147" y="1624660"/>
            <a:ext cx="369332" cy="2233781"/>
          </a:xfrm>
          <a:prstGeom prst="rect">
            <a:avLst/>
          </a:prstGeom>
          <a:noFill/>
        </p:spPr>
        <p:txBody>
          <a:bodyPr vert="vert270" wrap="square">
            <a:spAutoFit/>
          </a:bodyPr>
          <a:lstStyle/>
          <a:p>
            <a:pPr algn="ctr" rtl="0">
              <a:defRPr sz="10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altLang="ko-KR" sz="1200" b="0" dirty="0"/>
              <a:t>Relative expression/</a:t>
            </a:r>
            <a:r>
              <a:rPr lang="en-US" altLang="ko-KR" sz="1200" b="0" i="1" dirty="0"/>
              <a:t>OsUBQ1</a:t>
            </a:r>
            <a:endParaRPr lang="x-none" altLang="ko-KR" sz="1200" b="0" i="1" dirty="0"/>
          </a:p>
        </p:txBody>
      </p:sp>
      <p:sp>
        <p:nvSpPr>
          <p:cNvPr id="4" name="직사각형 3"/>
          <p:cNvSpPr/>
          <p:nvPr/>
        </p:nvSpPr>
        <p:spPr>
          <a:xfrm>
            <a:off x="1183038" y="2014781"/>
            <a:ext cx="1912224" cy="175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직사각형 83"/>
          <p:cNvSpPr/>
          <p:nvPr/>
        </p:nvSpPr>
        <p:spPr>
          <a:xfrm>
            <a:off x="4340980" y="2024898"/>
            <a:ext cx="1912224" cy="175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5" name="직사각형 84"/>
          <p:cNvSpPr/>
          <p:nvPr/>
        </p:nvSpPr>
        <p:spPr>
          <a:xfrm>
            <a:off x="1183038" y="3351826"/>
            <a:ext cx="1912224" cy="175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6" name="직사각형 85"/>
          <p:cNvSpPr/>
          <p:nvPr/>
        </p:nvSpPr>
        <p:spPr>
          <a:xfrm>
            <a:off x="4340980" y="3351826"/>
            <a:ext cx="1912224" cy="175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7" name="직사각형 86"/>
          <p:cNvSpPr/>
          <p:nvPr/>
        </p:nvSpPr>
        <p:spPr>
          <a:xfrm>
            <a:off x="1183038" y="4687991"/>
            <a:ext cx="1912224" cy="1756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33B0CDA5-2A2F-4050-B771-A2D3FB195DAA}"/>
              </a:ext>
            </a:extLst>
          </p:cNvPr>
          <p:cNvSpPr txBox="1"/>
          <p:nvPr/>
        </p:nvSpPr>
        <p:spPr>
          <a:xfrm>
            <a:off x="5710559" y="814325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2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34B03A8-DF55-4B5D-8F00-BDEABCFA82F4}"/>
              </a:ext>
            </a:extLst>
          </p:cNvPr>
          <p:cNvSpPr txBox="1"/>
          <p:nvPr/>
        </p:nvSpPr>
        <p:spPr>
          <a:xfrm>
            <a:off x="2552617" y="814325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1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BFFF90C7-0C58-4DB5-8AAA-E8386EC3AB4F}"/>
              </a:ext>
            </a:extLst>
          </p:cNvPr>
          <p:cNvSpPr txBox="1"/>
          <p:nvPr/>
        </p:nvSpPr>
        <p:spPr>
          <a:xfrm>
            <a:off x="5710559" y="2145958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4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7FD3989-E78C-4EC9-8E2D-C96B150E2D9D}"/>
              </a:ext>
            </a:extLst>
          </p:cNvPr>
          <p:cNvSpPr txBox="1"/>
          <p:nvPr/>
        </p:nvSpPr>
        <p:spPr>
          <a:xfrm>
            <a:off x="5710559" y="3482909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6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C43F8D5-1B0D-4F2D-8D78-3C8D66435521}"/>
              </a:ext>
            </a:extLst>
          </p:cNvPr>
          <p:cNvSpPr txBox="1"/>
          <p:nvPr/>
        </p:nvSpPr>
        <p:spPr>
          <a:xfrm>
            <a:off x="2552617" y="2145958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3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C25D0EB-424B-4F72-A9BF-AD676AFF4438}"/>
              </a:ext>
            </a:extLst>
          </p:cNvPr>
          <p:cNvSpPr txBox="1"/>
          <p:nvPr/>
        </p:nvSpPr>
        <p:spPr>
          <a:xfrm>
            <a:off x="2552617" y="3482909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5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B543D419-5791-45EB-BB88-663795996A13}"/>
              </a:ext>
            </a:extLst>
          </p:cNvPr>
          <p:cNvSpPr txBox="1"/>
          <p:nvPr/>
        </p:nvSpPr>
        <p:spPr>
          <a:xfrm>
            <a:off x="2552617" y="4765571"/>
            <a:ext cx="542645" cy="226591"/>
          </a:xfrm>
          <a:prstGeom prst="rect">
            <a:avLst/>
          </a:prstGeom>
          <a:noFill/>
        </p:spPr>
        <p:txBody>
          <a:bodyPr wrap="square" lIns="36000" tIns="36000" rIns="36000" bIns="36000" rtlCol="0">
            <a:spAutoFit/>
          </a:bodyPr>
          <a:lstStyle/>
          <a:p>
            <a:pPr algn="r"/>
            <a:r>
              <a:rPr lang="en-US" altLang="ko-KR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OsCHI7</a:t>
            </a:r>
            <a:endParaRPr lang="ko-KR" altLang="en-US" sz="10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269299" y="6158478"/>
            <a:ext cx="17235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ime after UV treatment 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428716" y="4827989"/>
            <a:ext cx="17235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dirty="0">
                <a:latin typeface="Arial" panose="020B0604020202020204" pitchFamily="34" charset="0"/>
                <a:cs typeface="Arial" panose="020B0604020202020204" pitchFamily="34" charset="0"/>
              </a:rPr>
              <a:t>Time after UV treatment </a:t>
            </a:r>
            <a:endParaRPr lang="ko-KR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13335" y="7540953"/>
            <a:ext cx="639284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. Expression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in rice leaves in response to UV treatment was analyzed using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Rice plants treated with UV irradiation were collected at the designated time points and used to examine the expression of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 ubiquitin gene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UBQ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amplified using specific primers and used as an internal control. The expression level of each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CHI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 was presented as the relative expression compared to the 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UBQ1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level. Asterisks indicate significant differences (</a:t>
            </a:r>
            <a:r>
              <a:rPr lang="en-US" altLang="ko-K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t-test) between UV-untreated and UV-treated samples. 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576E941-8014-43DC-BFE0-46670DA633D7}"/>
              </a:ext>
            </a:extLst>
          </p:cNvPr>
          <p:cNvSpPr txBox="1"/>
          <p:nvPr/>
        </p:nvSpPr>
        <p:spPr>
          <a:xfrm>
            <a:off x="1582559" y="2077344"/>
            <a:ext cx="298908" cy="375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Chart 3" title="Chart">
            <a:extLst>
              <a:ext uri="{FF2B5EF4-FFF2-40B4-BE49-F238E27FC236}">
                <a16:creationId xmlns:a16="http://schemas.microsoft.com/office/drawing/2014/main" id="{00000000-0008-0000-05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1957293"/>
              </p:ext>
            </p:extLst>
          </p:nvPr>
        </p:nvGraphicFramePr>
        <p:xfrm>
          <a:off x="3819203" y="3364208"/>
          <a:ext cx="2640050" cy="18286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2511582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32</TotalTime>
  <Words>775</Words>
  <Application>Microsoft Office PowerPoint</Application>
  <PresentationFormat>On-screen Show (4:3)</PresentationFormat>
  <Paragraphs>16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6" baseType="lpstr">
      <vt:lpstr>굴림</vt:lpstr>
      <vt:lpstr>맑은 고딕</vt:lpstr>
      <vt:lpstr>Arial</vt:lpstr>
      <vt:lpstr>Calibri</vt:lpstr>
      <vt:lpstr>Calibri Light</vt:lpstr>
      <vt:lpstr>Palatino Linotype</vt:lpstr>
      <vt:lpstr>Times New Roman</vt:lpstr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HC</dc:creator>
  <cp:lastModifiedBy>MDPI</cp:lastModifiedBy>
  <cp:revision>207</cp:revision>
  <cp:lastPrinted>2020-03-10T08:35:44Z</cp:lastPrinted>
  <dcterms:created xsi:type="dcterms:W3CDTF">2020-02-29T08:06:52Z</dcterms:created>
  <dcterms:modified xsi:type="dcterms:W3CDTF">2021-09-26T02:16:27Z</dcterms:modified>
</cp:coreProperties>
</file>